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6.xml" ContentType="application/vnd.openxmlformats-officedocument.themeOverr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theme/themeOverride7.xml" ContentType="application/vnd.openxmlformats-officedocument.themeOverrid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theme/themeOverride8.xml" ContentType="application/vnd.openxmlformats-officedocument.themeOverrid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theme/themeOverride9.xml" ContentType="application/vnd.openxmlformats-officedocument.themeOverrid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theme/themeOverride10.xml" ContentType="application/vnd.openxmlformats-officedocument.themeOverrid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theme/themeOverride11.xml" ContentType="application/vnd.openxmlformats-officedocument.themeOverrid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theme/themeOverride12.xml" ContentType="application/vnd.openxmlformats-officedocument.themeOverrid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theme/themeOverride13.xml" ContentType="application/vnd.openxmlformats-officedocument.themeOverrid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theme/themeOverride14.xml" ContentType="application/vnd.openxmlformats-officedocument.themeOverrid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9392900" cy="14057313"/>
  <p:notesSz cx="6858000" cy="9144000"/>
  <p:defaultTextStyle>
    <a:defPPr>
      <a:defRPr lang="fr-FR"/>
    </a:defPPr>
    <a:lvl1pPr marL="0" algn="l" defTabSz="1605595" rtl="0" eaLnBrk="1" latinLnBrk="0" hangingPunct="1">
      <a:defRPr sz="3161" kern="1200">
        <a:solidFill>
          <a:schemeClr val="tx1"/>
        </a:solidFill>
        <a:latin typeface="+mn-lt"/>
        <a:ea typeface="+mn-ea"/>
        <a:cs typeface="+mn-cs"/>
      </a:defRPr>
    </a:lvl1pPr>
    <a:lvl2pPr marL="802797" algn="l" defTabSz="1605595" rtl="0" eaLnBrk="1" latinLnBrk="0" hangingPunct="1">
      <a:defRPr sz="3161" kern="1200">
        <a:solidFill>
          <a:schemeClr val="tx1"/>
        </a:solidFill>
        <a:latin typeface="+mn-lt"/>
        <a:ea typeface="+mn-ea"/>
        <a:cs typeface="+mn-cs"/>
      </a:defRPr>
    </a:lvl2pPr>
    <a:lvl3pPr marL="1605595" algn="l" defTabSz="1605595" rtl="0" eaLnBrk="1" latinLnBrk="0" hangingPunct="1">
      <a:defRPr sz="3161" kern="1200">
        <a:solidFill>
          <a:schemeClr val="tx1"/>
        </a:solidFill>
        <a:latin typeface="+mn-lt"/>
        <a:ea typeface="+mn-ea"/>
        <a:cs typeface="+mn-cs"/>
      </a:defRPr>
    </a:lvl3pPr>
    <a:lvl4pPr marL="2408392" algn="l" defTabSz="1605595" rtl="0" eaLnBrk="1" latinLnBrk="0" hangingPunct="1">
      <a:defRPr sz="3161" kern="1200">
        <a:solidFill>
          <a:schemeClr val="tx1"/>
        </a:solidFill>
        <a:latin typeface="+mn-lt"/>
        <a:ea typeface="+mn-ea"/>
        <a:cs typeface="+mn-cs"/>
      </a:defRPr>
    </a:lvl4pPr>
    <a:lvl5pPr marL="3211190" algn="l" defTabSz="1605595" rtl="0" eaLnBrk="1" latinLnBrk="0" hangingPunct="1">
      <a:defRPr sz="3161" kern="1200">
        <a:solidFill>
          <a:schemeClr val="tx1"/>
        </a:solidFill>
        <a:latin typeface="+mn-lt"/>
        <a:ea typeface="+mn-ea"/>
        <a:cs typeface="+mn-cs"/>
      </a:defRPr>
    </a:lvl5pPr>
    <a:lvl6pPr marL="4013987" algn="l" defTabSz="1605595" rtl="0" eaLnBrk="1" latinLnBrk="0" hangingPunct="1">
      <a:defRPr sz="3161" kern="1200">
        <a:solidFill>
          <a:schemeClr val="tx1"/>
        </a:solidFill>
        <a:latin typeface="+mn-lt"/>
        <a:ea typeface="+mn-ea"/>
        <a:cs typeface="+mn-cs"/>
      </a:defRPr>
    </a:lvl6pPr>
    <a:lvl7pPr marL="4816785" algn="l" defTabSz="1605595" rtl="0" eaLnBrk="1" latinLnBrk="0" hangingPunct="1">
      <a:defRPr sz="3161" kern="1200">
        <a:solidFill>
          <a:schemeClr val="tx1"/>
        </a:solidFill>
        <a:latin typeface="+mn-lt"/>
        <a:ea typeface="+mn-ea"/>
        <a:cs typeface="+mn-cs"/>
      </a:defRPr>
    </a:lvl7pPr>
    <a:lvl8pPr marL="5619582" algn="l" defTabSz="1605595" rtl="0" eaLnBrk="1" latinLnBrk="0" hangingPunct="1">
      <a:defRPr sz="3161" kern="1200">
        <a:solidFill>
          <a:schemeClr val="tx1"/>
        </a:solidFill>
        <a:latin typeface="+mn-lt"/>
        <a:ea typeface="+mn-ea"/>
        <a:cs typeface="+mn-cs"/>
      </a:defRPr>
    </a:lvl8pPr>
    <a:lvl9pPr marL="6422380" algn="l" defTabSz="1605595" rtl="0" eaLnBrk="1" latinLnBrk="0" hangingPunct="1">
      <a:defRPr sz="316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 varScale="1">
        <p:scale>
          <a:sx n="42" d="100"/>
          <a:sy n="42" d="100"/>
        </p:scale>
        <p:origin x="54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\\CLR1DONNEES\0163xxxx\01636758\Desktop\Colosph&#232;res\Transcriptome\Toute%20les%20CTC\PCR%20valid\R&#233;sultats%20PCR%202.xlsx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0.xml"/><Relationship Id="rId2" Type="http://schemas.microsoft.com/office/2011/relationships/chartColorStyle" Target="colors10.xml"/><Relationship Id="rId1" Type="http://schemas.microsoft.com/office/2011/relationships/chartStyle" Target="style10.xml"/><Relationship Id="rId4" Type="http://schemas.openxmlformats.org/officeDocument/2006/relationships/oleObject" Target="file:///\\CLR1DONNEES\0163xxxx\01636758\Desktop\Colosph&#232;res\Transcriptome\Toute%20les%20CTC\PCR%20valid\R&#233;sultats%20PCR%202.xlsx" TargetMode="Externa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1.xml"/><Relationship Id="rId2" Type="http://schemas.microsoft.com/office/2011/relationships/chartColorStyle" Target="colors11.xml"/><Relationship Id="rId1" Type="http://schemas.microsoft.com/office/2011/relationships/chartStyle" Target="style11.xml"/><Relationship Id="rId4" Type="http://schemas.openxmlformats.org/officeDocument/2006/relationships/oleObject" Target="file:///\\CLR1DONNEES\0163xxxx\01636758\Desktop\Colosph&#232;res\Transcriptome\Toute%20les%20CTC\PCR%20valid\R&#233;sultats%20PCR%202.xlsx" TargetMode="Externa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2.xml"/><Relationship Id="rId2" Type="http://schemas.microsoft.com/office/2011/relationships/chartColorStyle" Target="colors12.xml"/><Relationship Id="rId1" Type="http://schemas.microsoft.com/office/2011/relationships/chartStyle" Target="style12.xml"/><Relationship Id="rId4" Type="http://schemas.openxmlformats.org/officeDocument/2006/relationships/oleObject" Target="file:///\\CLR1DONNEES\0163xxxx\01636758\Desktop\Colosph&#232;res\Transcriptome\Toute%20les%20CTC\PCR%20valid\R&#233;sultats%20PCR%202.xlsx" TargetMode="Externa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3.xml"/><Relationship Id="rId2" Type="http://schemas.microsoft.com/office/2011/relationships/chartColorStyle" Target="colors13.xml"/><Relationship Id="rId1" Type="http://schemas.microsoft.com/office/2011/relationships/chartStyle" Target="style13.xml"/><Relationship Id="rId4" Type="http://schemas.openxmlformats.org/officeDocument/2006/relationships/oleObject" Target="file:///\\CLR1DONNEES\0163xxxx\01636758\Desktop\Colosph&#232;res\Transcriptome\Toute%20les%20CTC\PCR%20valid\R&#233;sultats%20PCR%202.xlsx" TargetMode="Externa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4.xml"/><Relationship Id="rId2" Type="http://schemas.microsoft.com/office/2011/relationships/chartColorStyle" Target="colors14.xml"/><Relationship Id="rId1" Type="http://schemas.microsoft.com/office/2011/relationships/chartStyle" Target="style14.xml"/><Relationship Id="rId4" Type="http://schemas.openxmlformats.org/officeDocument/2006/relationships/oleObject" Target="file:///\\CLR1DONNEES\0163xxxx\01636758\Desktop\Colosph&#232;res\Transcriptome\Toute%20les%20CTC\PCR%20valid\R&#233;sultats%20PCR%202.xlsx" TargetMode="Externa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\\CLR1DONNEES\0163xxxx\01636758\Desktop\Colosph&#232;res\Transcriptome\Toute%20les%20CTC\PCR%20valid\R&#233;sultats%20PCR%202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\\CLR1DONNEES\0163xxxx\01636758\Desktop\Colosph&#232;res\Transcriptome\Toute%20les%20CTC\PCR%20valid\R&#233;sultats%20PCR%202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\\CLR1DONNEES\0163xxxx\01636758\Desktop\Colosph&#232;res\Transcriptome\Toute%20les%20CTC\PCR%20valid\R&#233;sultats%20PCR%202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\\CLR1DONNEES\0163xxxx\01636758\Desktop\Colosph&#232;res\Transcriptome\Toute%20les%20CTC\PCR%20valid\R&#233;sultats%20PCR%202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\\CLR1DONNEES\0163xxxx\01636758\Desktop\Colosph&#232;res\Transcriptome\Toute%20les%20CTC\PCR%20valid\R&#233;sultats%20PCR%202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file:///\\CLR1DONNEES\0163xxxx\01636758\Desktop\Colosph&#232;res\Transcriptome\Toute%20les%20CTC\PCR%20valid\R&#233;sultats%20PCR%202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oleObject" Target="file:///\\CLR1DONNEES\0163xxxx\01636758\Desktop\Colosph&#232;res\Transcriptome\Toute%20les%20CTC\PCR%20valid\R&#233;sultats%20PCR%202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7.xml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oleObject" Target="file:///\\CLR1DONNEES\0163xxxx\01636758\Desktop\Colosph&#232;res\Transcriptome\Toute%20les%20CTC\PCR%20valid\R&#233;sultats%20PCR%202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8.xml"/><Relationship Id="rId2" Type="http://schemas.microsoft.com/office/2011/relationships/chartColorStyle" Target="colors8.xml"/><Relationship Id="rId1" Type="http://schemas.microsoft.com/office/2011/relationships/chartStyle" Target="style8.xml"/><Relationship Id="rId4" Type="http://schemas.openxmlformats.org/officeDocument/2006/relationships/oleObject" Target="file:///\\CLR1DONNEES\0163xxxx\01636758\Desktop\Colosph&#232;res\Transcriptome\Toute%20les%20CTC\PCR%20valid\R&#233;sultats%20PCR%202.xlsx" TargetMode="Externa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9.xml"/><Relationship Id="rId2" Type="http://schemas.microsoft.com/office/2011/relationships/chartColorStyle" Target="colors9.xml"/><Relationship Id="rId1" Type="http://schemas.microsoft.com/office/2011/relationships/chartStyle" Target="style9.xml"/><Relationship Id="rId4" Type="http://schemas.openxmlformats.org/officeDocument/2006/relationships/oleObject" Target="file:///\\CLR1DONNEES\0163xxxx\01636758\Desktop\Colosph&#232;res\Transcriptome\Toute%20les%20CTC\PCR%20valid\R&#233;sultats%20PCR%20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7!$A$2</c:f>
              <c:strCache>
                <c:ptCount val="1"/>
                <c:pt idx="0">
                  <c:v>TM4SF4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tint val="50000"/>
                    <a:satMod val="300000"/>
                  </a:schemeClr>
                </a:gs>
                <a:gs pos="35000">
                  <a:schemeClr val="dk1">
                    <a:tint val="88500"/>
                    <a:tint val="37000"/>
                    <a:satMod val="300000"/>
                  </a:schemeClr>
                </a:gs>
                <a:gs pos="100000">
                  <a:schemeClr val="dk1">
                    <a:tint val="88500"/>
                    <a:tint val="15000"/>
                    <a:satMod val="350000"/>
                  </a:schemeClr>
                </a:gs>
              </a:gsLst>
              <a:lin ang="16200000" scaled="1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Feuil7!$B$3:$J$3</c:f>
                <c:numCache>
                  <c:formatCode>General</c:formatCode>
                  <c:ptCount val="9"/>
                  <c:pt idx="0">
                    <c:v>0.60792911341050837</c:v>
                  </c:pt>
                  <c:pt idx="1">
                    <c:v>0.50383047921800406</c:v>
                  </c:pt>
                  <c:pt idx="2">
                    <c:v>7.9459720207936888E-2</c:v>
                  </c:pt>
                  <c:pt idx="3">
                    <c:v>1.1493761721285058</c:v>
                  </c:pt>
                  <c:pt idx="4">
                    <c:v>4.9977005514273429</c:v>
                  </c:pt>
                  <c:pt idx="5">
                    <c:v>3.7597927756982537</c:v>
                  </c:pt>
                  <c:pt idx="6">
                    <c:v>2.4151445858038421</c:v>
                  </c:pt>
                  <c:pt idx="7">
                    <c:v>0.18917360120909166</c:v>
                  </c:pt>
                  <c:pt idx="8">
                    <c:v>0.28535691592360352</c:v>
                  </c:pt>
                </c:numCache>
              </c:numRef>
            </c:plus>
            <c:minus>
              <c:numRef>
                <c:f>Feuil7!$B$3:$J$3</c:f>
                <c:numCache>
                  <c:formatCode>General</c:formatCode>
                  <c:ptCount val="9"/>
                  <c:pt idx="0">
                    <c:v>0.60792911341050837</c:v>
                  </c:pt>
                  <c:pt idx="1">
                    <c:v>0.50383047921800406</c:v>
                  </c:pt>
                  <c:pt idx="2">
                    <c:v>7.9459720207936888E-2</c:v>
                  </c:pt>
                  <c:pt idx="3">
                    <c:v>1.1493761721285058</c:v>
                  </c:pt>
                  <c:pt idx="4">
                    <c:v>4.9977005514273429</c:v>
                  </c:pt>
                  <c:pt idx="5">
                    <c:v>3.7597927756982537</c:v>
                  </c:pt>
                  <c:pt idx="6">
                    <c:v>2.4151445858038421</c:v>
                  </c:pt>
                  <c:pt idx="7">
                    <c:v>0.18917360120909166</c:v>
                  </c:pt>
                  <c:pt idx="8">
                    <c:v>0.28535691592360352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Feuil7!$B$1:$J$1</c:f>
              <c:strCache>
                <c:ptCount val="9"/>
                <c:pt idx="0">
                  <c:v>41</c:v>
                </c:pt>
                <c:pt idx="1">
                  <c:v>41.4</c:v>
                </c:pt>
                <c:pt idx="2">
                  <c:v>41.5A</c:v>
                </c:pt>
                <c:pt idx="3">
                  <c:v>41.5B</c:v>
                </c:pt>
                <c:pt idx="4">
                  <c:v>41.5C</c:v>
                </c:pt>
                <c:pt idx="5">
                  <c:v>41.5D</c:v>
                </c:pt>
                <c:pt idx="6">
                  <c:v>41.5E</c:v>
                </c:pt>
                <c:pt idx="7">
                  <c:v>41.5F</c:v>
                </c:pt>
                <c:pt idx="8">
                  <c:v>41.5G</c:v>
                </c:pt>
              </c:strCache>
            </c:strRef>
          </c:cat>
          <c:val>
            <c:numRef>
              <c:f>Feuil7!$B$2:$J$2</c:f>
              <c:numCache>
                <c:formatCode>0.000</c:formatCode>
                <c:ptCount val="9"/>
                <c:pt idx="0">
                  <c:v>6.4108073537892478</c:v>
                </c:pt>
                <c:pt idx="1">
                  <c:v>20.401335183523017</c:v>
                </c:pt>
                <c:pt idx="2">
                  <c:v>0.35948685904917682</c:v>
                </c:pt>
                <c:pt idx="3">
                  <c:v>3.1897219411475839</c:v>
                </c:pt>
                <c:pt idx="4">
                  <c:v>75.795233775058918</c:v>
                </c:pt>
                <c:pt idx="5">
                  <c:v>44.436652688959633</c:v>
                </c:pt>
                <c:pt idx="6">
                  <c:v>37.96171999346118</c:v>
                </c:pt>
                <c:pt idx="7">
                  <c:v>1.680934363639351</c:v>
                </c:pt>
                <c:pt idx="8">
                  <c:v>4.42007989187000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1C6-42D5-A7CD-1E99A24D3E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-146776272"/>
        <c:axId val="-146764304"/>
      </c:barChart>
      <c:catAx>
        <c:axId val="-1467762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6764304"/>
        <c:crosses val="autoZero"/>
        <c:auto val="1"/>
        <c:lblAlgn val="ctr"/>
        <c:lblOffset val="100"/>
        <c:noMultiLvlLbl val="0"/>
      </c:catAx>
      <c:valAx>
        <c:axId val="-146764304"/>
        <c:scaling>
          <c:orientation val="minMax"/>
        </c:scaling>
        <c:delete val="0"/>
        <c:axPos val="l"/>
        <c:numFmt formatCode="0.00" sourceLinked="0"/>
        <c:majorTickMark val="none"/>
        <c:minorTickMark val="none"/>
        <c:tickLblPos val="nextTo"/>
        <c:spPr>
          <a:noFill/>
          <a:ln>
            <a:solidFill>
              <a:sysClr val="window" lastClr="FFFFFF">
                <a:lumMod val="85000"/>
              </a:sys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67762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4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7!$A$20</c:f>
              <c:strCache>
                <c:ptCount val="1"/>
                <c:pt idx="0">
                  <c:v>ABCB1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tint val="50000"/>
                    <a:satMod val="300000"/>
                  </a:schemeClr>
                </a:gs>
                <a:gs pos="35000">
                  <a:schemeClr val="dk1">
                    <a:tint val="88500"/>
                    <a:tint val="37000"/>
                    <a:satMod val="300000"/>
                  </a:schemeClr>
                </a:gs>
                <a:gs pos="100000">
                  <a:schemeClr val="dk1">
                    <a:tint val="88500"/>
                    <a:tint val="15000"/>
                    <a:satMod val="350000"/>
                  </a:schemeClr>
                </a:gs>
              </a:gsLst>
              <a:lin ang="16200000" scaled="1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Feuil7!$B$21:$J$21</c:f>
                <c:numCache>
                  <c:formatCode>General</c:formatCode>
                  <c:ptCount val="9"/>
                  <c:pt idx="0">
                    <c:v>4.353570858973753</c:v>
                  </c:pt>
                  <c:pt idx="1">
                    <c:v>0.69038457613292969</c:v>
                  </c:pt>
                  <c:pt idx="2">
                    <c:v>0.13343428372355895</c:v>
                  </c:pt>
                  <c:pt idx="3">
                    <c:v>0.23757776174897496</c:v>
                  </c:pt>
                  <c:pt idx="4">
                    <c:v>1.1383064894728008</c:v>
                  </c:pt>
                  <c:pt idx="5">
                    <c:v>1.3663754267528549</c:v>
                  </c:pt>
                  <c:pt idx="6">
                    <c:v>2.3698973111175792</c:v>
                  </c:pt>
                  <c:pt idx="7">
                    <c:v>0.25564152452407352</c:v>
                  </c:pt>
                  <c:pt idx="8">
                    <c:v>0.31985062096168843</c:v>
                  </c:pt>
                </c:numCache>
              </c:numRef>
            </c:plus>
            <c:minus>
              <c:numRef>
                <c:f>Feuil7!$B$21:$J$21</c:f>
                <c:numCache>
                  <c:formatCode>General</c:formatCode>
                  <c:ptCount val="9"/>
                  <c:pt idx="0">
                    <c:v>4.353570858973753</c:v>
                  </c:pt>
                  <c:pt idx="1">
                    <c:v>0.69038457613292969</c:v>
                  </c:pt>
                  <c:pt idx="2">
                    <c:v>0.13343428372355895</c:v>
                  </c:pt>
                  <c:pt idx="3">
                    <c:v>0.23757776174897496</c:v>
                  </c:pt>
                  <c:pt idx="4">
                    <c:v>1.1383064894728008</c:v>
                  </c:pt>
                  <c:pt idx="5">
                    <c:v>1.3663754267528549</c:v>
                  </c:pt>
                  <c:pt idx="6">
                    <c:v>2.3698973111175792</c:v>
                  </c:pt>
                  <c:pt idx="7">
                    <c:v>0.25564152452407352</c:v>
                  </c:pt>
                  <c:pt idx="8">
                    <c:v>0.31985062096168843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Feuil7!$B$1:$J$1</c:f>
              <c:strCache>
                <c:ptCount val="9"/>
                <c:pt idx="0">
                  <c:v>41</c:v>
                </c:pt>
                <c:pt idx="1">
                  <c:v>41.4</c:v>
                </c:pt>
                <c:pt idx="2">
                  <c:v>41.5A</c:v>
                </c:pt>
                <c:pt idx="3">
                  <c:v>41.5B</c:v>
                </c:pt>
                <c:pt idx="4">
                  <c:v>41.5C</c:v>
                </c:pt>
                <c:pt idx="5">
                  <c:v>41.5D</c:v>
                </c:pt>
                <c:pt idx="6">
                  <c:v>41.5E</c:v>
                </c:pt>
                <c:pt idx="7">
                  <c:v>41.5F</c:v>
                </c:pt>
                <c:pt idx="8">
                  <c:v>41.5G</c:v>
                </c:pt>
              </c:strCache>
            </c:strRef>
          </c:cat>
          <c:val>
            <c:numRef>
              <c:f>Feuil7!$B$20:$J$20</c:f>
              <c:numCache>
                <c:formatCode>0.000</c:formatCode>
                <c:ptCount val="9"/>
                <c:pt idx="0">
                  <c:v>8.384221829221767</c:v>
                </c:pt>
                <c:pt idx="1">
                  <c:v>2.0733929378230549</c:v>
                </c:pt>
                <c:pt idx="2">
                  <c:v>0.31748765677777019</c:v>
                </c:pt>
                <c:pt idx="3">
                  <c:v>0.39417817115230819</c:v>
                </c:pt>
                <c:pt idx="4">
                  <c:v>3.2659123967018764</c:v>
                </c:pt>
                <c:pt idx="5">
                  <c:v>3.5942413165648071</c:v>
                </c:pt>
                <c:pt idx="6">
                  <c:v>4.3635000720773407</c:v>
                </c:pt>
                <c:pt idx="7">
                  <c:v>0.31242290980968573</c:v>
                </c:pt>
                <c:pt idx="8">
                  <c:v>0.360269414411174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5B2-47A2-8F5D-68E3A87B3C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-144750112"/>
        <c:axId val="-144748480"/>
      </c:barChart>
      <c:catAx>
        <c:axId val="-1447501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748480"/>
        <c:crosses val="autoZero"/>
        <c:auto val="1"/>
        <c:lblAlgn val="ctr"/>
        <c:lblOffset val="100"/>
        <c:noMultiLvlLbl val="0"/>
      </c:catAx>
      <c:valAx>
        <c:axId val="-144748480"/>
        <c:scaling>
          <c:orientation val="minMax"/>
        </c:scaling>
        <c:delete val="0"/>
        <c:axPos val="l"/>
        <c:numFmt formatCode="#,##0.00" sourceLinked="0"/>
        <c:majorTickMark val="none"/>
        <c:minorTickMark val="none"/>
        <c:tickLblPos val="nextTo"/>
        <c:spPr>
          <a:noFill/>
          <a:ln>
            <a:solidFill>
              <a:sysClr val="window" lastClr="FFFFFF">
                <a:lumMod val="85000"/>
              </a:sys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7501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4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7!$A$22</c:f>
              <c:strCache>
                <c:ptCount val="1"/>
                <c:pt idx="0">
                  <c:v>AMACR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tint val="50000"/>
                    <a:satMod val="300000"/>
                  </a:schemeClr>
                </a:gs>
                <a:gs pos="35000">
                  <a:schemeClr val="dk1">
                    <a:tint val="88500"/>
                    <a:tint val="37000"/>
                    <a:satMod val="300000"/>
                  </a:schemeClr>
                </a:gs>
                <a:gs pos="100000">
                  <a:schemeClr val="dk1">
                    <a:tint val="88500"/>
                    <a:tint val="15000"/>
                    <a:satMod val="350000"/>
                  </a:schemeClr>
                </a:gs>
              </a:gsLst>
              <a:lin ang="16200000" scaled="1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Feuil7!$B$23:$J$23</c:f>
                <c:numCache>
                  <c:formatCode>General</c:formatCode>
                  <c:ptCount val="9"/>
                  <c:pt idx="0">
                    <c:v>1.8303623134050244</c:v>
                  </c:pt>
                  <c:pt idx="1">
                    <c:v>0.35586589434276156</c:v>
                  </c:pt>
                  <c:pt idx="2">
                    <c:v>6.2054232062830859E-2</c:v>
                  </c:pt>
                  <c:pt idx="3">
                    <c:v>0.10494889607561531</c:v>
                  </c:pt>
                  <c:pt idx="4">
                    <c:v>0.17475192549331645</c:v>
                  </c:pt>
                  <c:pt idx="5">
                    <c:v>8.4859994126559993E-2</c:v>
                  </c:pt>
                  <c:pt idx="6">
                    <c:v>0.16764199609969932</c:v>
                  </c:pt>
                  <c:pt idx="7">
                    <c:v>0.34553038102736444</c:v>
                  </c:pt>
                  <c:pt idx="8">
                    <c:v>0.28920099965838014</c:v>
                  </c:pt>
                </c:numCache>
              </c:numRef>
            </c:plus>
            <c:minus>
              <c:numRef>
                <c:f>Feuil7!$B$23:$J$23</c:f>
                <c:numCache>
                  <c:formatCode>General</c:formatCode>
                  <c:ptCount val="9"/>
                  <c:pt idx="0">
                    <c:v>1.8303623134050244</c:v>
                  </c:pt>
                  <c:pt idx="1">
                    <c:v>0.35586589434276156</c:v>
                  </c:pt>
                  <c:pt idx="2">
                    <c:v>6.2054232062830859E-2</c:v>
                  </c:pt>
                  <c:pt idx="3">
                    <c:v>0.10494889607561531</c:v>
                  </c:pt>
                  <c:pt idx="4">
                    <c:v>0.17475192549331645</c:v>
                  </c:pt>
                  <c:pt idx="5">
                    <c:v>8.4859994126559993E-2</c:v>
                  </c:pt>
                  <c:pt idx="6">
                    <c:v>0.16764199609969932</c:v>
                  </c:pt>
                  <c:pt idx="7">
                    <c:v>0.34553038102736444</c:v>
                  </c:pt>
                  <c:pt idx="8">
                    <c:v>0.28920099965838014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Feuil7!$B$1:$J$1</c:f>
              <c:strCache>
                <c:ptCount val="9"/>
                <c:pt idx="0">
                  <c:v>41</c:v>
                </c:pt>
                <c:pt idx="1">
                  <c:v>41.4</c:v>
                </c:pt>
                <c:pt idx="2">
                  <c:v>41.5A</c:v>
                </c:pt>
                <c:pt idx="3">
                  <c:v>41.5B</c:v>
                </c:pt>
                <c:pt idx="4">
                  <c:v>41.5C</c:v>
                </c:pt>
                <c:pt idx="5">
                  <c:v>41.5D</c:v>
                </c:pt>
                <c:pt idx="6">
                  <c:v>41.5E</c:v>
                </c:pt>
                <c:pt idx="7">
                  <c:v>41.5F</c:v>
                </c:pt>
                <c:pt idx="8">
                  <c:v>41.5G</c:v>
                </c:pt>
              </c:strCache>
            </c:strRef>
          </c:cat>
          <c:val>
            <c:numRef>
              <c:f>Feuil7!$B$22:$J$22</c:f>
              <c:numCache>
                <c:formatCode>0.000</c:formatCode>
                <c:ptCount val="9"/>
                <c:pt idx="0">
                  <c:v>3.5322071290413355</c:v>
                </c:pt>
                <c:pt idx="1">
                  <c:v>0.77033770261297152</c:v>
                </c:pt>
                <c:pt idx="2">
                  <c:v>0.41387012544534341</c:v>
                </c:pt>
                <c:pt idx="3">
                  <c:v>0.21119648907025365</c:v>
                </c:pt>
                <c:pt idx="4">
                  <c:v>0.44631893122510591</c:v>
                </c:pt>
                <c:pt idx="5">
                  <c:v>0.34321537584325418</c:v>
                </c:pt>
                <c:pt idx="6">
                  <c:v>0.26904943563565975</c:v>
                </c:pt>
                <c:pt idx="7">
                  <c:v>0.72217743268540546</c:v>
                </c:pt>
                <c:pt idx="8">
                  <c:v>0.502904622888626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1D0-49E2-9B21-22C3AF5C64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-144757728"/>
        <c:axId val="-144757184"/>
      </c:barChart>
      <c:catAx>
        <c:axId val="-1447577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757184"/>
        <c:crosses val="autoZero"/>
        <c:auto val="1"/>
        <c:lblAlgn val="ctr"/>
        <c:lblOffset val="100"/>
        <c:noMultiLvlLbl val="0"/>
      </c:catAx>
      <c:valAx>
        <c:axId val="-144757184"/>
        <c:scaling>
          <c:orientation val="minMax"/>
        </c:scaling>
        <c:delete val="0"/>
        <c:axPos val="l"/>
        <c:numFmt formatCode="#,##0.00" sourceLinked="0"/>
        <c:majorTickMark val="none"/>
        <c:minorTickMark val="none"/>
        <c:tickLblPos val="nextTo"/>
        <c:spPr>
          <a:noFill/>
          <a:ln>
            <a:solidFill>
              <a:sysClr val="window" lastClr="FFFFFF">
                <a:lumMod val="85000"/>
              </a:sys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7577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4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7!$A$24</c:f>
              <c:strCache>
                <c:ptCount val="1"/>
                <c:pt idx="0">
                  <c:v>CAPN13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tint val="50000"/>
                    <a:satMod val="300000"/>
                  </a:schemeClr>
                </a:gs>
                <a:gs pos="35000">
                  <a:schemeClr val="dk1">
                    <a:tint val="88500"/>
                    <a:tint val="37000"/>
                    <a:satMod val="300000"/>
                  </a:schemeClr>
                </a:gs>
                <a:gs pos="100000">
                  <a:schemeClr val="dk1">
                    <a:tint val="88500"/>
                    <a:tint val="15000"/>
                    <a:satMod val="350000"/>
                  </a:schemeClr>
                </a:gs>
              </a:gsLst>
              <a:lin ang="16200000" scaled="1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Feuil7!$B$25:$J$25</c:f>
                <c:numCache>
                  <c:formatCode>General</c:formatCode>
                  <c:ptCount val="9"/>
                  <c:pt idx="0">
                    <c:v>0.13677600141401869</c:v>
                  </c:pt>
                  <c:pt idx="1">
                    <c:v>8.2039895030290147E-2</c:v>
                  </c:pt>
                  <c:pt idx="2">
                    <c:v>5.9742920602343964E-2</c:v>
                  </c:pt>
                  <c:pt idx="3">
                    <c:v>8.6558605886029799E-8</c:v>
                  </c:pt>
                  <c:pt idx="4">
                    <c:v>5.1714250596981565E-2</c:v>
                  </c:pt>
                  <c:pt idx="5">
                    <c:v>0.19600895709532207</c:v>
                  </c:pt>
                  <c:pt idx="6">
                    <c:v>9.6381325695732364E-2</c:v>
                  </c:pt>
                  <c:pt idx="7">
                    <c:v>0.11590184520845402</c:v>
                  </c:pt>
                  <c:pt idx="8">
                    <c:v>0.19000734655462148</c:v>
                  </c:pt>
                </c:numCache>
              </c:numRef>
            </c:plus>
            <c:minus>
              <c:numRef>
                <c:f>Feuil7!$B$25:$J$25</c:f>
                <c:numCache>
                  <c:formatCode>General</c:formatCode>
                  <c:ptCount val="9"/>
                  <c:pt idx="0">
                    <c:v>0.13677600141401869</c:v>
                  </c:pt>
                  <c:pt idx="1">
                    <c:v>8.2039895030290147E-2</c:v>
                  </c:pt>
                  <c:pt idx="2">
                    <c:v>5.9742920602343964E-2</c:v>
                  </c:pt>
                  <c:pt idx="3">
                    <c:v>8.6558605886029799E-8</c:v>
                  </c:pt>
                  <c:pt idx="4">
                    <c:v>5.1714250596981565E-2</c:v>
                  </c:pt>
                  <c:pt idx="5">
                    <c:v>0.19600895709532207</c:v>
                  </c:pt>
                  <c:pt idx="6">
                    <c:v>9.6381325695732364E-2</c:v>
                  </c:pt>
                  <c:pt idx="7">
                    <c:v>0.11590184520845402</c:v>
                  </c:pt>
                  <c:pt idx="8">
                    <c:v>0.19000734655462148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Feuil7!$B$1:$J$1</c:f>
              <c:strCache>
                <c:ptCount val="9"/>
                <c:pt idx="0">
                  <c:v>41</c:v>
                </c:pt>
                <c:pt idx="1">
                  <c:v>41.4</c:v>
                </c:pt>
                <c:pt idx="2">
                  <c:v>41.5A</c:v>
                </c:pt>
                <c:pt idx="3">
                  <c:v>41.5B</c:v>
                </c:pt>
                <c:pt idx="4">
                  <c:v>41.5C</c:v>
                </c:pt>
                <c:pt idx="5">
                  <c:v>41.5D</c:v>
                </c:pt>
                <c:pt idx="6">
                  <c:v>41.5E</c:v>
                </c:pt>
                <c:pt idx="7">
                  <c:v>41.5F</c:v>
                </c:pt>
                <c:pt idx="8">
                  <c:v>41.5G</c:v>
                </c:pt>
              </c:strCache>
            </c:strRef>
          </c:cat>
          <c:val>
            <c:numRef>
              <c:f>Feuil7!$B$24:$J$24</c:f>
              <c:numCache>
                <c:formatCode>0.000</c:formatCode>
                <c:ptCount val="9"/>
                <c:pt idx="0">
                  <c:v>1.8536248442529555</c:v>
                </c:pt>
                <c:pt idx="1">
                  <c:v>0.12306011772977203</c:v>
                </c:pt>
                <c:pt idx="2">
                  <c:v>4.4807814902058735E-2</c:v>
                </c:pt>
                <c:pt idx="3">
                  <c:v>5.1628535755861301E-7</c:v>
                </c:pt>
                <c:pt idx="4">
                  <c:v>0.24527021586790856</c:v>
                </c:pt>
                <c:pt idx="5">
                  <c:v>0.57034271379514523</c:v>
                </c:pt>
                <c:pt idx="6">
                  <c:v>1.2764352151057241</c:v>
                </c:pt>
                <c:pt idx="7">
                  <c:v>8.692697118396954E-2</c:v>
                </c:pt>
                <c:pt idx="8">
                  <c:v>0.142505986242736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50F-42DE-AA75-8B70318DB2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-144152080"/>
        <c:axId val="-144156432"/>
      </c:barChart>
      <c:catAx>
        <c:axId val="-1441520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156432"/>
        <c:crosses val="autoZero"/>
        <c:auto val="1"/>
        <c:lblAlgn val="ctr"/>
        <c:lblOffset val="100"/>
        <c:noMultiLvlLbl val="0"/>
      </c:catAx>
      <c:valAx>
        <c:axId val="-144156432"/>
        <c:scaling>
          <c:orientation val="minMax"/>
        </c:scaling>
        <c:delete val="0"/>
        <c:axPos val="l"/>
        <c:numFmt formatCode="#,##0.0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1520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4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7!$A$26</c:f>
              <c:strCache>
                <c:ptCount val="1"/>
                <c:pt idx="0">
                  <c:v>TFF2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tint val="50000"/>
                    <a:satMod val="300000"/>
                  </a:schemeClr>
                </a:gs>
                <a:gs pos="35000">
                  <a:schemeClr val="dk1">
                    <a:tint val="88500"/>
                    <a:tint val="37000"/>
                    <a:satMod val="300000"/>
                  </a:schemeClr>
                </a:gs>
                <a:gs pos="100000">
                  <a:schemeClr val="dk1">
                    <a:tint val="88500"/>
                    <a:tint val="15000"/>
                    <a:satMod val="350000"/>
                  </a:schemeClr>
                </a:gs>
              </a:gsLst>
              <a:lin ang="16200000" scaled="1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Feuil7!$B$27:$J$27</c:f>
                <c:numCache>
                  <c:formatCode>General</c:formatCode>
                  <c:ptCount val="9"/>
                  <c:pt idx="0">
                    <c:v>1.8607119272881525E-2</c:v>
                  </c:pt>
                  <c:pt idx="1">
                    <c:v>9.7672809728781187E-2</c:v>
                  </c:pt>
                  <c:pt idx="2">
                    <c:v>1.609050440004018</c:v>
                  </c:pt>
                  <c:pt idx="3">
                    <c:v>0.52775516894197161</c:v>
                  </c:pt>
                  <c:pt idx="4">
                    <c:v>0.33123391963381027</c:v>
                  </c:pt>
                  <c:pt idx="5">
                    <c:v>7.1893307232097151E-2</c:v>
                  </c:pt>
                  <c:pt idx="6">
                    <c:v>1.92503005478936E-2</c:v>
                  </c:pt>
                  <c:pt idx="7">
                    <c:v>6.5809600928405265E-2</c:v>
                  </c:pt>
                  <c:pt idx="8">
                    <c:v>0.24245408131515878</c:v>
                  </c:pt>
                </c:numCache>
              </c:numRef>
            </c:plus>
            <c:minus>
              <c:numRef>
                <c:f>Feuil7!$B$27:$J$27</c:f>
                <c:numCache>
                  <c:formatCode>General</c:formatCode>
                  <c:ptCount val="9"/>
                  <c:pt idx="0">
                    <c:v>1.8607119272881525E-2</c:v>
                  </c:pt>
                  <c:pt idx="1">
                    <c:v>9.7672809728781187E-2</c:v>
                  </c:pt>
                  <c:pt idx="2">
                    <c:v>1.609050440004018</c:v>
                  </c:pt>
                  <c:pt idx="3">
                    <c:v>0.52775516894197161</c:v>
                  </c:pt>
                  <c:pt idx="4">
                    <c:v>0.33123391963381027</c:v>
                  </c:pt>
                  <c:pt idx="5">
                    <c:v>7.1893307232097151E-2</c:v>
                  </c:pt>
                  <c:pt idx="6">
                    <c:v>1.92503005478936E-2</c:v>
                  </c:pt>
                  <c:pt idx="7">
                    <c:v>6.5809600928405265E-2</c:v>
                  </c:pt>
                  <c:pt idx="8">
                    <c:v>0.24245408131515878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Feuil7!$B$1:$J$1</c:f>
              <c:strCache>
                <c:ptCount val="9"/>
                <c:pt idx="0">
                  <c:v>41</c:v>
                </c:pt>
                <c:pt idx="1">
                  <c:v>41.4</c:v>
                </c:pt>
                <c:pt idx="2">
                  <c:v>41.5A</c:v>
                </c:pt>
                <c:pt idx="3">
                  <c:v>41.5B</c:v>
                </c:pt>
                <c:pt idx="4">
                  <c:v>41.5C</c:v>
                </c:pt>
                <c:pt idx="5">
                  <c:v>41.5D</c:v>
                </c:pt>
                <c:pt idx="6">
                  <c:v>41.5E</c:v>
                </c:pt>
                <c:pt idx="7">
                  <c:v>41.5F</c:v>
                </c:pt>
                <c:pt idx="8">
                  <c:v>41.5G</c:v>
                </c:pt>
              </c:strCache>
            </c:strRef>
          </c:cat>
          <c:val>
            <c:numRef>
              <c:f>Feuil7!$B$26:$J$26</c:f>
              <c:numCache>
                <c:formatCode>0.000</c:formatCode>
                <c:ptCount val="9"/>
                <c:pt idx="0">
                  <c:v>2.7910934568190743E-2</c:v>
                </c:pt>
                <c:pt idx="1">
                  <c:v>0.78624624842574564</c:v>
                </c:pt>
                <c:pt idx="2">
                  <c:v>7.9643564645544194</c:v>
                </c:pt>
                <c:pt idx="3">
                  <c:v>2.4429569860179208</c:v>
                </c:pt>
                <c:pt idx="4">
                  <c:v>1.399186130568052</c:v>
                </c:pt>
                <c:pt idx="5">
                  <c:v>0.67465139595763846</c:v>
                </c:pt>
                <c:pt idx="6">
                  <c:v>0.75051141150200762</c:v>
                </c:pt>
                <c:pt idx="7">
                  <c:v>1.0877332803928217</c:v>
                </c:pt>
                <c:pt idx="8">
                  <c:v>2.0475075820630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1A8-45E5-A69A-E69B859E56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-144145552"/>
        <c:axId val="-144154256"/>
      </c:barChart>
      <c:catAx>
        <c:axId val="-1441455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154256"/>
        <c:crosses val="autoZero"/>
        <c:auto val="1"/>
        <c:lblAlgn val="ctr"/>
        <c:lblOffset val="100"/>
        <c:noMultiLvlLbl val="0"/>
      </c:catAx>
      <c:valAx>
        <c:axId val="-144154256"/>
        <c:scaling>
          <c:orientation val="minMax"/>
        </c:scaling>
        <c:delete val="0"/>
        <c:axPos val="l"/>
        <c:numFmt formatCode="#,##0.00" sourceLinked="0"/>
        <c:majorTickMark val="none"/>
        <c:minorTickMark val="none"/>
        <c:tickLblPos val="nextTo"/>
        <c:spPr>
          <a:noFill/>
          <a:ln>
            <a:solidFill>
              <a:sysClr val="window" lastClr="FFFFFF">
                <a:lumMod val="85000"/>
              </a:sys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1455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4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7!$A$28</c:f>
              <c:strCache>
                <c:ptCount val="1"/>
                <c:pt idx="0">
                  <c:v>OLFM4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tint val="50000"/>
                    <a:satMod val="300000"/>
                  </a:schemeClr>
                </a:gs>
                <a:gs pos="35000">
                  <a:schemeClr val="dk1">
                    <a:tint val="88500"/>
                    <a:tint val="37000"/>
                    <a:satMod val="300000"/>
                  </a:schemeClr>
                </a:gs>
                <a:gs pos="100000">
                  <a:schemeClr val="dk1">
                    <a:tint val="88500"/>
                    <a:tint val="15000"/>
                    <a:satMod val="350000"/>
                  </a:schemeClr>
                </a:gs>
              </a:gsLst>
              <a:lin ang="16200000" scaled="1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Feuil7!$B$29:$J$29</c:f>
                <c:numCache>
                  <c:formatCode>General</c:formatCode>
                  <c:ptCount val="9"/>
                  <c:pt idx="0">
                    <c:v>1.1324836086258094</c:v>
                  </c:pt>
                  <c:pt idx="1">
                    <c:v>2.6007085677642944E-2</c:v>
                  </c:pt>
                  <c:pt idx="2">
                    <c:v>2.7218500561195402E-2</c:v>
                  </c:pt>
                  <c:pt idx="3">
                    <c:v>2.3565632282158706E-2</c:v>
                  </c:pt>
                  <c:pt idx="4">
                    <c:v>0.24731597769650179</c:v>
                  </c:pt>
                  <c:pt idx="5">
                    <c:v>1.838295499346744E-2</c:v>
                  </c:pt>
                  <c:pt idx="6">
                    <c:v>4.1879066305360334E-2</c:v>
                  </c:pt>
                  <c:pt idx="7">
                    <c:v>7.3270504234163511E-8</c:v>
                  </c:pt>
                  <c:pt idx="8">
                    <c:v>3.2674217612526903E-2</c:v>
                  </c:pt>
                </c:numCache>
              </c:numRef>
            </c:plus>
            <c:minus>
              <c:numRef>
                <c:f>Feuil7!$B$29:$J$29</c:f>
                <c:numCache>
                  <c:formatCode>General</c:formatCode>
                  <c:ptCount val="9"/>
                  <c:pt idx="0">
                    <c:v>1.1324836086258094</c:v>
                  </c:pt>
                  <c:pt idx="1">
                    <c:v>2.6007085677642944E-2</c:v>
                  </c:pt>
                  <c:pt idx="2">
                    <c:v>2.7218500561195402E-2</c:v>
                  </c:pt>
                  <c:pt idx="3">
                    <c:v>2.3565632282158706E-2</c:v>
                  </c:pt>
                  <c:pt idx="4">
                    <c:v>0.24731597769650179</c:v>
                  </c:pt>
                  <c:pt idx="5">
                    <c:v>1.838295499346744E-2</c:v>
                  </c:pt>
                  <c:pt idx="6">
                    <c:v>4.1879066305360334E-2</c:v>
                  </c:pt>
                  <c:pt idx="7">
                    <c:v>7.3270504234163511E-8</c:v>
                  </c:pt>
                  <c:pt idx="8">
                    <c:v>3.2674217612526903E-2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Feuil7!$B$1:$J$1</c:f>
              <c:strCache>
                <c:ptCount val="9"/>
                <c:pt idx="0">
                  <c:v>41</c:v>
                </c:pt>
                <c:pt idx="1">
                  <c:v>41.4</c:v>
                </c:pt>
                <c:pt idx="2">
                  <c:v>41.5A</c:v>
                </c:pt>
                <c:pt idx="3">
                  <c:v>41.5B</c:v>
                </c:pt>
                <c:pt idx="4">
                  <c:v>41.5C</c:v>
                </c:pt>
                <c:pt idx="5">
                  <c:v>41.5D</c:v>
                </c:pt>
                <c:pt idx="6">
                  <c:v>41.5E</c:v>
                </c:pt>
                <c:pt idx="7">
                  <c:v>41.5F</c:v>
                </c:pt>
                <c:pt idx="8">
                  <c:v>41.5G</c:v>
                </c:pt>
              </c:strCache>
            </c:strRef>
          </c:cat>
          <c:val>
            <c:numRef>
              <c:f>Feuil7!$B$28:$J$28</c:f>
              <c:numCache>
                <c:formatCode>0.000</c:formatCode>
                <c:ptCount val="9"/>
                <c:pt idx="0">
                  <c:v>3.4525215610331514</c:v>
                </c:pt>
                <c:pt idx="1">
                  <c:v>0.10844101582138853</c:v>
                </c:pt>
                <c:pt idx="2">
                  <c:v>0.11161494665848397</c:v>
                </c:pt>
                <c:pt idx="3">
                  <c:v>3.5348834870686796E-2</c:v>
                </c:pt>
                <c:pt idx="4">
                  <c:v>0.76438156955684</c:v>
                </c:pt>
                <c:pt idx="5">
                  <c:v>0.10265968437992871</c:v>
                </c:pt>
                <c:pt idx="6">
                  <c:v>8.379659144235925E-2</c:v>
                </c:pt>
                <c:pt idx="7">
                  <c:v>5.8121199167605016E-7</c:v>
                </c:pt>
                <c:pt idx="8">
                  <c:v>9.910950781506960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EBA-4C83-A919-E0B7351ABF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-144143920"/>
        <c:axId val="-144155888"/>
      </c:barChart>
      <c:catAx>
        <c:axId val="-144143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155888"/>
        <c:crosses val="autoZero"/>
        <c:auto val="1"/>
        <c:lblAlgn val="ctr"/>
        <c:lblOffset val="100"/>
        <c:noMultiLvlLbl val="0"/>
      </c:catAx>
      <c:valAx>
        <c:axId val="-144155888"/>
        <c:scaling>
          <c:orientation val="minMax"/>
        </c:scaling>
        <c:delete val="0"/>
        <c:axPos val="l"/>
        <c:numFmt formatCode="#,##0.00" sourceLinked="0"/>
        <c:majorTickMark val="none"/>
        <c:minorTickMark val="none"/>
        <c:tickLblPos val="nextTo"/>
        <c:spPr>
          <a:noFill/>
          <a:ln>
            <a:solidFill>
              <a:sysClr val="window" lastClr="FFFFFF">
                <a:lumMod val="85000"/>
              </a:sys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1439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4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7!$A$81</c:f>
              <c:strCache>
                <c:ptCount val="1"/>
                <c:pt idx="0">
                  <c:v>ST3GAL1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tint val="50000"/>
                    <a:satMod val="300000"/>
                  </a:schemeClr>
                </a:gs>
                <a:gs pos="35000">
                  <a:schemeClr val="dk1">
                    <a:tint val="88500"/>
                    <a:tint val="37000"/>
                    <a:satMod val="300000"/>
                  </a:schemeClr>
                </a:gs>
                <a:gs pos="100000">
                  <a:schemeClr val="dk1">
                    <a:tint val="88500"/>
                    <a:tint val="15000"/>
                    <a:satMod val="350000"/>
                  </a:schemeClr>
                </a:gs>
              </a:gsLst>
              <a:lin ang="16200000" scaled="1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Feuil7!$B$82:$J$82</c:f>
                <c:numCache>
                  <c:formatCode>General</c:formatCode>
                  <c:ptCount val="9"/>
                  <c:pt idx="0">
                    <c:v>0.1175914740401655</c:v>
                  </c:pt>
                  <c:pt idx="1">
                    <c:v>0.27861114455662622</c:v>
                  </c:pt>
                  <c:pt idx="2">
                    <c:v>0.53973349839019225</c:v>
                  </c:pt>
                  <c:pt idx="3">
                    <c:v>0.46283413147519231</c:v>
                  </c:pt>
                  <c:pt idx="4">
                    <c:v>0.11990311605120633</c:v>
                  </c:pt>
                  <c:pt idx="5">
                    <c:v>0.12467698724260179</c:v>
                  </c:pt>
                  <c:pt idx="6">
                    <c:v>0.13793615925307109</c:v>
                  </c:pt>
                  <c:pt idx="7">
                    <c:v>0.80481170408762293</c:v>
                  </c:pt>
                  <c:pt idx="8">
                    <c:v>0.83775799205313295</c:v>
                  </c:pt>
                </c:numCache>
              </c:numRef>
            </c:plus>
            <c:minus>
              <c:numRef>
                <c:f>Feuil7!$B$82:$J$82</c:f>
                <c:numCache>
                  <c:formatCode>General</c:formatCode>
                  <c:ptCount val="9"/>
                  <c:pt idx="0">
                    <c:v>0.1175914740401655</c:v>
                  </c:pt>
                  <c:pt idx="1">
                    <c:v>0.27861114455662622</c:v>
                  </c:pt>
                  <c:pt idx="2">
                    <c:v>0.53973349839019225</c:v>
                  </c:pt>
                  <c:pt idx="3">
                    <c:v>0.46283413147519231</c:v>
                  </c:pt>
                  <c:pt idx="4">
                    <c:v>0.11990311605120633</c:v>
                  </c:pt>
                  <c:pt idx="5">
                    <c:v>0.12467698724260179</c:v>
                  </c:pt>
                  <c:pt idx="6">
                    <c:v>0.13793615925307109</c:v>
                  </c:pt>
                  <c:pt idx="7">
                    <c:v>0.80481170408762293</c:v>
                  </c:pt>
                  <c:pt idx="8">
                    <c:v>0.83775799205313295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Feuil7!$B$1:$J$1</c:f>
              <c:strCache>
                <c:ptCount val="9"/>
                <c:pt idx="0">
                  <c:v>41</c:v>
                </c:pt>
                <c:pt idx="1">
                  <c:v>41.4</c:v>
                </c:pt>
                <c:pt idx="2">
                  <c:v>41.5A</c:v>
                </c:pt>
                <c:pt idx="3">
                  <c:v>41.5B</c:v>
                </c:pt>
                <c:pt idx="4">
                  <c:v>41.5C</c:v>
                </c:pt>
                <c:pt idx="5">
                  <c:v>41.5D</c:v>
                </c:pt>
                <c:pt idx="6">
                  <c:v>41.5E</c:v>
                </c:pt>
                <c:pt idx="7">
                  <c:v>41.5F</c:v>
                </c:pt>
                <c:pt idx="8">
                  <c:v>41.5G</c:v>
                </c:pt>
              </c:strCache>
            </c:strRef>
          </c:cat>
          <c:val>
            <c:numRef>
              <c:f>Feuil7!$B$81:$J$81</c:f>
              <c:numCache>
                <c:formatCode>0.000</c:formatCode>
                <c:ptCount val="9"/>
                <c:pt idx="0">
                  <c:v>0.1681064521876269</c:v>
                </c:pt>
                <c:pt idx="1">
                  <c:v>0.51328488151170981</c:v>
                </c:pt>
                <c:pt idx="2">
                  <c:v>1.3150248934261286</c:v>
                </c:pt>
                <c:pt idx="3">
                  <c:v>0.88760851446110778</c:v>
                </c:pt>
                <c:pt idx="4">
                  <c:v>0.37468207049217123</c:v>
                </c:pt>
                <c:pt idx="5">
                  <c:v>0.33336690376091754</c:v>
                </c:pt>
                <c:pt idx="6">
                  <c:v>0.37768087170980641</c:v>
                </c:pt>
                <c:pt idx="7">
                  <c:v>1.5150864304321832</c:v>
                </c:pt>
                <c:pt idx="8">
                  <c:v>1.79046794371996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72B-4220-B045-FDCE46B0AD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-144153712"/>
        <c:axId val="-144143376"/>
      </c:barChart>
      <c:catAx>
        <c:axId val="-144153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143376"/>
        <c:crosses val="autoZero"/>
        <c:auto val="1"/>
        <c:lblAlgn val="ctr"/>
        <c:lblOffset val="100"/>
        <c:noMultiLvlLbl val="0"/>
      </c:catAx>
      <c:valAx>
        <c:axId val="-144143376"/>
        <c:scaling>
          <c:orientation val="minMax"/>
        </c:scaling>
        <c:delete val="0"/>
        <c:axPos val="l"/>
        <c:numFmt formatCode="#,##0.00" sourceLinked="0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1537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7!$A$83</c:f>
              <c:strCache>
                <c:ptCount val="1"/>
                <c:pt idx="0">
                  <c:v>LGALS1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tint val="50000"/>
                    <a:satMod val="300000"/>
                  </a:schemeClr>
                </a:gs>
                <a:gs pos="35000">
                  <a:schemeClr val="dk1">
                    <a:tint val="88500"/>
                    <a:tint val="37000"/>
                    <a:satMod val="300000"/>
                  </a:schemeClr>
                </a:gs>
                <a:gs pos="100000">
                  <a:schemeClr val="dk1">
                    <a:tint val="88500"/>
                    <a:tint val="15000"/>
                    <a:satMod val="350000"/>
                  </a:schemeClr>
                </a:gs>
              </a:gsLst>
              <a:lin ang="16200000" scaled="1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Feuil7!$B$84:$J$84</c:f>
                <c:numCache>
                  <c:formatCode>General</c:formatCode>
                  <c:ptCount val="9"/>
                  <c:pt idx="0">
                    <c:v>0.16247617966332714</c:v>
                  </c:pt>
                  <c:pt idx="1">
                    <c:v>4.5382033803593478</c:v>
                  </c:pt>
                  <c:pt idx="2">
                    <c:v>3.4208128469991492</c:v>
                  </c:pt>
                  <c:pt idx="3">
                    <c:v>1.7699246529491173</c:v>
                  </c:pt>
                  <c:pt idx="4">
                    <c:v>3.7343540647502231</c:v>
                  </c:pt>
                  <c:pt idx="5">
                    <c:v>1.2884792392412379</c:v>
                  </c:pt>
                  <c:pt idx="6">
                    <c:v>1.9125627966594925</c:v>
                  </c:pt>
                  <c:pt idx="7">
                    <c:v>9.7099215791072222</c:v>
                  </c:pt>
                  <c:pt idx="8">
                    <c:v>7.3460358290293861</c:v>
                  </c:pt>
                </c:numCache>
              </c:numRef>
            </c:plus>
            <c:minus>
              <c:numRef>
                <c:f>Feuil7!$B$84:$J$84</c:f>
                <c:numCache>
                  <c:formatCode>General</c:formatCode>
                  <c:ptCount val="9"/>
                  <c:pt idx="0">
                    <c:v>0.16247617966332714</c:v>
                  </c:pt>
                  <c:pt idx="1">
                    <c:v>4.5382033803593478</c:v>
                  </c:pt>
                  <c:pt idx="2">
                    <c:v>3.4208128469991492</c:v>
                  </c:pt>
                  <c:pt idx="3">
                    <c:v>1.7699246529491173</c:v>
                  </c:pt>
                  <c:pt idx="4">
                    <c:v>3.7343540647502231</c:v>
                  </c:pt>
                  <c:pt idx="5">
                    <c:v>1.2884792392412379</c:v>
                  </c:pt>
                  <c:pt idx="6">
                    <c:v>1.9125627966594925</c:v>
                  </c:pt>
                  <c:pt idx="7">
                    <c:v>9.7099215791072222</c:v>
                  </c:pt>
                  <c:pt idx="8">
                    <c:v>7.3460358290293861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Feuil7!$B$1:$J$1</c:f>
              <c:strCache>
                <c:ptCount val="9"/>
                <c:pt idx="0">
                  <c:v>41</c:v>
                </c:pt>
                <c:pt idx="1">
                  <c:v>41.4</c:v>
                </c:pt>
                <c:pt idx="2">
                  <c:v>41.5A</c:v>
                </c:pt>
                <c:pt idx="3">
                  <c:v>41.5B</c:v>
                </c:pt>
                <c:pt idx="4">
                  <c:v>41.5C</c:v>
                </c:pt>
                <c:pt idx="5">
                  <c:v>41.5D</c:v>
                </c:pt>
                <c:pt idx="6">
                  <c:v>41.5E</c:v>
                </c:pt>
                <c:pt idx="7">
                  <c:v>41.5F</c:v>
                </c:pt>
                <c:pt idx="8">
                  <c:v>41.5G</c:v>
                </c:pt>
              </c:strCache>
            </c:strRef>
          </c:cat>
          <c:val>
            <c:numRef>
              <c:f>Feuil7!$B$83:$J$83</c:f>
              <c:numCache>
                <c:formatCode>0.000</c:formatCode>
                <c:ptCount val="9"/>
                <c:pt idx="0">
                  <c:v>0.55411595935601243</c:v>
                </c:pt>
                <c:pt idx="1">
                  <c:v>14.948162376249286</c:v>
                </c:pt>
                <c:pt idx="2">
                  <c:v>10.219794008236212</c:v>
                </c:pt>
                <c:pt idx="3">
                  <c:v>4.717626286606424</c:v>
                </c:pt>
                <c:pt idx="4">
                  <c:v>7.5009775187529968</c:v>
                </c:pt>
                <c:pt idx="5">
                  <c:v>3.8789769504129978</c:v>
                </c:pt>
                <c:pt idx="6">
                  <c:v>4.8573227835738875</c:v>
                </c:pt>
                <c:pt idx="7">
                  <c:v>18.453873144017262</c:v>
                </c:pt>
                <c:pt idx="8">
                  <c:v>17.4186869008293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691-4817-B8FB-94C9D4DB4C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-144149904"/>
        <c:axId val="-144145008"/>
      </c:barChart>
      <c:catAx>
        <c:axId val="-1441499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145008"/>
        <c:crosses val="autoZero"/>
        <c:auto val="1"/>
        <c:lblAlgn val="ctr"/>
        <c:lblOffset val="100"/>
        <c:noMultiLvlLbl val="0"/>
      </c:catAx>
      <c:valAx>
        <c:axId val="-144145008"/>
        <c:scaling>
          <c:orientation val="minMax"/>
        </c:scaling>
        <c:delete val="0"/>
        <c:axPos val="l"/>
        <c:numFmt formatCode="#,##0.00" sourceLinked="0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1499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7!$A$4</c:f>
              <c:strCache>
                <c:ptCount val="1"/>
                <c:pt idx="0">
                  <c:v>SPRR1A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tint val="50000"/>
                    <a:satMod val="300000"/>
                  </a:schemeClr>
                </a:gs>
                <a:gs pos="35000">
                  <a:schemeClr val="dk1">
                    <a:tint val="88500"/>
                    <a:tint val="37000"/>
                    <a:satMod val="300000"/>
                  </a:schemeClr>
                </a:gs>
                <a:gs pos="100000">
                  <a:schemeClr val="dk1">
                    <a:tint val="88500"/>
                    <a:tint val="15000"/>
                    <a:satMod val="350000"/>
                  </a:schemeClr>
                </a:gs>
              </a:gsLst>
              <a:lin ang="16200000" scaled="1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Feuil7!$B$5:$J$5</c:f>
                <c:numCache>
                  <c:formatCode>General</c:formatCode>
                  <c:ptCount val="9"/>
                  <c:pt idx="0">
                    <c:v>0.25048628277252527</c:v>
                  </c:pt>
                  <c:pt idx="1">
                    <c:v>0.98713925500092348</c:v>
                  </c:pt>
                  <c:pt idx="2">
                    <c:v>0.25917712794720654</c:v>
                  </c:pt>
                  <c:pt idx="3">
                    <c:v>0.22479861524366537</c:v>
                  </c:pt>
                  <c:pt idx="4">
                    <c:v>0.82916226628806822</c:v>
                  </c:pt>
                  <c:pt idx="5">
                    <c:v>0.53744118195161583</c:v>
                  </c:pt>
                  <c:pt idx="6">
                    <c:v>0.87017612549748247</c:v>
                  </c:pt>
                  <c:pt idx="7">
                    <c:v>2.8206738453999365</c:v>
                  </c:pt>
                  <c:pt idx="8">
                    <c:v>0.19917205441159194</c:v>
                  </c:pt>
                </c:numCache>
              </c:numRef>
            </c:plus>
            <c:minus>
              <c:numRef>
                <c:f>Feuil7!$B$5:$J$5</c:f>
                <c:numCache>
                  <c:formatCode>General</c:formatCode>
                  <c:ptCount val="9"/>
                  <c:pt idx="0">
                    <c:v>0.25048628277252527</c:v>
                  </c:pt>
                  <c:pt idx="1">
                    <c:v>0.98713925500092348</c:v>
                  </c:pt>
                  <c:pt idx="2">
                    <c:v>0.25917712794720654</c:v>
                  </c:pt>
                  <c:pt idx="3">
                    <c:v>0.22479861524366537</c:v>
                  </c:pt>
                  <c:pt idx="4">
                    <c:v>0.82916226628806822</c:v>
                  </c:pt>
                  <c:pt idx="5">
                    <c:v>0.53744118195161583</c:v>
                  </c:pt>
                  <c:pt idx="6">
                    <c:v>0.87017612549748247</c:v>
                  </c:pt>
                  <c:pt idx="7">
                    <c:v>2.8206738453999365</c:v>
                  </c:pt>
                  <c:pt idx="8">
                    <c:v>0.19917205441159194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Feuil7!$B$1:$J$1</c:f>
              <c:strCache>
                <c:ptCount val="9"/>
                <c:pt idx="0">
                  <c:v>41</c:v>
                </c:pt>
                <c:pt idx="1">
                  <c:v>41.4</c:v>
                </c:pt>
                <c:pt idx="2">
                  <c:v>41.5A</c:v>
                </c:pt>
                <c:pt idx="3">
                  <c:v>41.5B</c:v>
                </c:pt>
                <c:pt idx="4">
                  <c:v>41.5C</c:v>
                </c:pt>
                <c:pt idx="5">
                  <c:v>41.5D</c:v>
                </c:pt>
                <c:pt idx="6">
                  <c:v>41.5E</c:v>
                </c:pt>
                <c:pt idx="7">
                  <c:v>41.5F</c:v>
                </c:pt>
                <c:pt idx="8">
                  <c:v>41.5G</c:v>
                </c:pt>
              </c:strCache>
            </c:strRef>
          </c:cat>
          <c:val>
            <c:numRef>
              <c:f>Feuil7!$B$4:$J$4</c:f>
              <c:numCache>
                <c:formatCode>0.000</c:formatCode>
                <c:ptCount val="9"/>
                <c:pt idx="0">
                  <c:v>0.88122916659395945</c:v>
                </c:pt>
                <c:pt idx="1">
                  <c:v>4.1845658045931344</c:v>
                </c:pt>
                <c:pt idx="2">
                  <c:v>0.65488151113137638</c:v>
                </c:pt>
                <c:pt idx="3">
                  <c:v>0.62741731443078586</c:v>
                </c:pt>
                <c:pt idx="4">
                  <c:v>2.3460737438457042</c:v>
                </c:pt>
                <c:pt idx="5">
                  <c:v>1.5558041591573228</c:v>
                </c:pt>
                <c:pt idx="6">
                  <c:v>2.4933680099519369</c:v>
                </c:pt>
                <c:pt idx="7">
                  <c:v>2.4124091417233582</c:v>
                </c:pt>
                <c:pt idx="8">
                  <c:v>0.499491413384953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9B8-46A7-A59C-52197E7097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-146761584"/>
        <c:axId val="-146770288"/>
      </c:barChart>
      <c:catAx>
        <c:axId val="-1467615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6770288"/>
        <c:crosses val="autoZero"/>
        <c:auto val="1"/>
        <c:lblAlgn val="ctr"/>
        <c:lblOffset val="100"/>
        <c:noMultiLvlLbl val="0"/>
      </c:catAx>
      <c:valAx>
        <c:axId val="-146770288"/>
        <c:scaling>
          <c:orientation val="minMax"/>
        </c:scaling>
        <c:delete val="0"/>
        <c:axPos val="l"/>
        <c:numFmt formatCode="#,##0.00" sourceLinked="0"/>
        <c:majorTickMark val="none"/>
        <c:minorTickMark val="none"/>
        <c:tickLblPos val="nextTo"/>
        <c:spPr>
          <a:noFill/>
          <a:ln>
            <a:solidFill>
              <a:sysClr val="window" lastClr="FFFFFF">
                <a:lumMod val="85000"/>
              </a:sys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67615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7!$A$6</c:f>
              <c:strCache>
                <c:ptCount val="1"/>
                <c:pt idx="0">
                  <c:v>VGLL1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tint val="50000"/>
                    <a:satMod val="300000"/>
                  </a:schemeClr>
                </a:gs>
                <a:gs pos="35000">
                  <a:schemeClr val="dk1">
                    <a:tint val="88500"/>
                    <a:tint val="37000"/>
                    <a:satMod val="300000"/>
                  </a:schemeClr>
                </a:gs>
                <a:gs pos="100000">
                  <a:schemeClr val="dk1">
                    <a:tint val="88500"/>
                    <a:tint val="15000"/>
                    <a:satMod val="350000"/>
                  </a:schemeClr>
                </a:gs>
              </a:gsLst>
              <a:lin ang="16200000" scaled="1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Feuil7!$B$7:$J$7</c:f>
                <c:numCache>
                  <c:formatCode>General</c:formatCode>
                  <c:ptCount val="9"/>
                  <c:pt idx="0">
                    <c:v>2.1129832341638663E-2</c:v>
                  </c:pt>
                  <c:pt idx="1">
                    <c:v>4.1160652257765266E-2</c:v>
                  </c:pt>
                  <c:pt idx="2">
                    <c:v>0.13571974479124593</c:v>
                  </c:pt>
                  <c:pt idx="3">
                    <c:v>0.15062710233333682</c:v>
                  </c:pt>
                  <c:pt idx="4">
                    <c:v>2.1529064652253488E-2</c:v>
                  </c:pt>
                  <c:pt idx="5">
                    <c:v>2.5343265536288254E-2</c:v>
                  </c:pt>
                  <c:pt idx="6">
                    <c:v>3.2344418235423042E-2</c:v>
                  </c:pt>
                  <c:pt idx="7">
                    <c:v>0.44731419511320486</c:v>
                  </c:pt>
                  <c:pt idx="8">
                    <c:v>0.16966382207701783</c:v>
                  </c:pt>
                </c:numCache>
              </c:numRef>
            </c:plus>
            <c:minus>
              <c:numRef>
                <c:f>Feuil7!$B$7:$J$7</c:f>
                <c:numCache>
                  <c:formatCode>General</c:formatCode>
                  <c:ptCount val="9"/>
                  <c:pt idx="0">
                    <c:v>2.1129832341638663E-2</c:v>
                  </c:pt>
                  <c:pt idx="1">
                    <c:v>4.1160652257765266E-2</c:v>
                  </c:pt>
                  <c:pt idx="2">
                    <c:v>0.13571974479124593</c:v>
                  </c:pt>
                  <c:pt idx="3">
                    <c:v>0.15062710233333682</c:v>
                  </c:pt>
                  <c:pt idx="4">
                    <c:v>2.1529064652253488E-2</c:v>
                  </c:pt>
                  <c:pt idx="5">
                    <c:v>2.5343265536288254E-2</c:v>
                  </c:pt>
                  <c:pt idx="6">
                    <c:v>3.2344418235423042E-2</c:v>
                  </c:pt>
                  <c:pt idx="7">
                    <c:v>0.44731419511320486</c:v>
                  </c:pt>
                  <c:pt idx="8">
                    <c:v>0.16966382207701783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Feuil7!$B$1:$J$1</c:f>
              <c:strCache>
                <c:ptCount val="9"/>
                <c:pt idx="0">
                  <c:v>41</c:v>
                </c:pt>
                <c:pt idx="1">
                  <c:v>41.4</c:v>
                </c:pt>
                <c:pt idx="2">
                  <c:v>41.5A</c:v>
                </c:pt>
                <c:pt idx="3">
                  <c:v>41.5B</c:v>
                </c:pt>
                <c:pt idx="4">
                  <c:v>41.5C</c:v>
                </c:pt>
                <c:pt idx="5">
                  <c:v>41.5D</c:v>
                </c:pt>
                <c:pt idx="6">
                  <c:v>41.5E</c:v>
                </c:pt>
                <c:pt idx="7">
                  <c:v>41.5F</c:v>
                </c:pt>
                <c:pt idx="8">
                  <c:v>41.5G</c:v>
                </c:pt>
              </c:strCache>
            </c:strRef>
          </c:cat>
          <c:val>
            <c:numRef>
              <c:f>Feuil7!$B$6:$J$6</c:f>
              <c:numCache>
                <c:formatCode>0.000</c:formatCode>
                <c:ptCount val="9"/>
                <c:pt idx="0">
                  <c:v>3.1694964014986692E-2</c:v>
                </c:pt>
                <c:pt idx="1">
                  <c:v>0.11255469675786556</c:v>
                </c:pt>
                <c:pt idx="2">
                  <c:v>1.1818388372518729</c:v>
                </c:pt>
                <c:pt idx="3">
                  <c:v>0.63890129784621319</c:v>
                </c:pt>
                <c:pt idx="4">
                  <c:v>5.8425861308806414E-2</c:v>
                </c:pt>
                <c:pt idx="5">
                  <c:v>3.80150829390151E-2</c:v>
                </c:pt>
                <c:pt idx="6">
                  <c:v>5.6050853618877274E-2</c:v>
                </c:pt>
                <c:pt idx="7">
                  <c:v>1.5519316846532185</c:v>
                </c:pt>
                <c:pt idx="8">
                  <c:v>1.40296366501185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0D5-489C-BBDC-939FA392DD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-146768112"/>
        <c:axId val="-146775728"/>
      </c:barChart>
      <c:catAx>
        <c:axId val="-1467681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6775728"/>
        <c:crosses val="autoZero"/>
        <c:auto val="1"/>
        <c:lblAlgn val="ctr"/>
        <c:lblOffset val="100"/>
        <c:noMultiLvlLbl val="0"/>
      </c:catAx>
      <c:valAx>
        <c:axId val="-146775728"/>
        <c:scaling>
          <c:orientation val="minMax"/>
        </c:scaling>
        <c:delete val="0"/>
        <c:axPos val="l"/>
        <c:numFmt formatCode="#,##0.00" sourceLinked="0"/>
        <c:majorTickMark val="none"/>
        <c:minorTickMark val="none"/>
        <c:tickLblPos val="nextTo"/>
        <c:spPr>
          <a:noFill/>
          <a:ln>
            <a:solidFill>
              <a:sysClr val="window" lastClr="FFFFFF">
                <a:lumMod val="85000"/>
              </a:sys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67681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7!$A$8</c:f>
              <c:strCache>
                <c:ptCount val="1"/>
                <c:pt idx="0">
                  <c:v>ODAM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tint val="50000"/>
                    <a:satMod val="300000"/>
                  </a:schemeClr>
                </a:gs>
                <a:gs pos="35000">
                  <a:schemeClr val="dk1">
                    <a:tint val="88500"/>
                    <a:tint val="37000"/>
                    <a:satMod val="300000"/>
                  </a:schemeClr>
                </a:gs>
                <a:gs pos="100000">
                  <a:schemeClr val="dk1">
                    <a:tint val="88500"/>
                    <a:tint val="15000"/>
                    <a:satMod val="350000"/>
                  </a:schemeClr>
                </a:gs>
              </a:gsLst>
              <a:lin ang="16200000" scaled="1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Feuil7!$B$9:$J$9</c:f>
                <c:numCache>
                  <c:formatCode>General</c:formatCode>
                  <c:ptCount val="9"/>
                  <c:pt idx="0">
                    <c:v>2.9452334166092036E-2</c:v>
                  </c:pt>
                  <c:pt idx="1">
                    <c:v>9.2821185440237416E-2</c:v>
                  </c:pt>
                  <c:pt idx="2">
                    <c:v>1.341475056340677</c:v>
                  </c:pt>
                  <c:pt idx="3">
                    <c:v>0.26201976060527243</c:v>
                  </c:pt>
                  <c:pt idx="4">
                    <c:v>5.491502168952577E-8</c:v>
                  </c:pt>
                  <c:pt idx="5">
                    <c:v>9.6267084085805044E-8</c:v>
                  </c:pt>
                  <c:pt idx="6">
                    <c:v>8.9857331999344519E-3</c:v>
                  </c:pt>
                  <c:pt idx="7">
                    <c:v>1.2600042407665779</c:v>
                  </c:pt>
                  <c:pt idx="8">
                    <c:v>0.50208777223935641</c:v>
                  </c:pt>
                </c:numCache>
              </c:numRef>
            </c:plus>
            <c:minus>
              <c:numRef>
                <c:f>Feuil7!$B$9:$J$9</c:f>
                <c:numCache>
                  <c:formatCode>General</c:formatCode>
                  <c:ptCount val="9"/>
                  <c:pt idx="0">
                    <c:v>2.9452334166092036E-2</c:v>
                  </c:pt>
                  <c:pt idx="1">
                    <c:v>9.2821185440237416E-2</c:v>
                  </c:pt>
                  <c:pt idx="2">
                    <c:v>1.341475056340677</c:v>
                  </c:pt>
                  <c:pt idx="3">
                    <c:v>0.26201976060527243</c:v>
                  </c:pt>
                  <c:pt idx="4">
                    <c:v>5.491502168952577E-8</c:v>
                  </c:pt>
                  <c:pt idx="5">
                    <c:v>9.6267084085805044E-8</c:v>
                  </c:pt>
                  <c:pt idx="6">
                    <c:v>8.9857331999344519E-3</c:v>
                  </c:pt>
                  <c:pt idx="7">
                    <c:v>1.2600042407665779</c:v>
                  </c:pt>
                  <c:pt idx="8">
                    <c:v>0.50208777223935641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Feuil7!$B$1:$J$1</c:f>
              <c:strCache>
                <c:ptCount val="9"/>
                <c:pt idx="0">
                  <c:v>41</c:v>
                </c:pt>
                <c:pt idx="1">
                  <c:v>41.4</c:v>
                </c:pt>
                <c:pt idx="2">
                  <c:v>41.5A</c:v>
                </c:pt>
                <c:pt idx="3">
                  <c:v>41.5B</c:v>
                </c:pt>
                <c:pt idx="4">
                  <c:v>41.5C</c:v>
                </c:pt>
                <c:pt idx="5">
                  <c:v>41.5D</c:v>
                </c:pt>
                <c:pt idx="6">
                  <c:v>41.5E</c:v>
                </c:pt>
                <c:pt idx="7">
                  <c:v>41.5F</c:v>
                </c:pt>
                <c:pt idx="8">
                  <c:v>41.5G</c:v>
                </c:pt>
              </c:strCache>
            </c:strRef>
          </c:cat>
          <c:val>
            <c:numRef>
              <c:f>Feuil7!$B$8:$J$8</c:f>
              <c:numCache>
                <c:formatCode>0.000</c:formatCode>
                <c:ptCount val="9"/>
                <c:pt idx="0">
                  <c:v>4.4178871057670828E-2</c:v>
                </c:pt>
                <c:pt idx="1">
                  <c:v>0.13923216600613986</c:v>
                </c:pt>
                <c:pt idx="2">
                  <c:v>5.6247922241129054</c:v>
                </c:pt>
                <c:pt idx="3">
                  <c:v>1.0628245045665585</c:v>
                </c:pt>
                <c:pt idx="4">
                  <c:v>3.0319395238337605E-7</c:v>
                </c:pt>
                <c:pt idx="5">
                  <c:v>2.3703133348150942E-7</c:v>
                </c:pt>
                <c:pt idx="6">
                  <c:v>6.7396175533297143E-3</c:v>
                </c:pt>
                <c:pt idx="7">
                  <c:v>5.8005811223534538</c:v>
                </c:pt>
                <c:pt idx="8">
                  <c:v>2.27092622554918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8EC-41F4-BDCF-FAD62ED82F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-146762672"/>
        <c:axId val="-146765936"/>
      </c:barChart>
      <c:catAx>
        <c:axId val="-1467626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6765936"/>
        <c:crosses val="autoZero"/>
        <c:auto val="1"/>
        <c:lblAlgn val="ctr"/>
        <c:lblOffset val="100"/>
        <c:noMultiLvlLbl val="0"/>
      </c:catAx>
      <c:valAx>
        <c:axId val="-146765936"/>
        <c:scaling>
          <c:orientation val="minMax"/>
        </c:scaling>
        <c:delete val="0"/>
        <c:axPos val="l"/>
        <c:numFmt formatCode="#,##0.00" sourceLinked="0"/>
        <c:majorTickMark val="none"/>
        <c:minorTickMark val="none"/>
        <c:tickLblPos val="nextTo"/>
        <c:spPr>
          <a:noFill/>
          <a:ln>
            <a:solidFill>
              <a:sysClr val="window" lastClr="FFFFFF">
                <a:lumMod val="85000"/>
              </a:sys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67626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7!$A$10</c:f>
              <c:strCache>
                <c:ptCount val="1"/>
                <c:pt idx="0">
                  <c:v>SERPINA3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tint val="50000"/>
                    <a:satMod val="300000"/>
                  </a:schemeClr>
                </a:gs>
                <a:gs pos="35000">
                  <a:schemeClr val="dk1">
                    <a:tint val="88500"/>
                    <a:tint val="37000"/>
                    <a:satMod val="300000"/>
                  </a:schemeClr>
                </a:gs>
                <a:gs pos="100000">
                  <a:schemeClr val="dk1">
                    <a:tint val="88500"/>
                    <a:tint val="15000"/>
                    <a:satMod val="350000"/>
                  </a:schemeClr>
                </a:gs>
              </a:gsLst>
              <a:lin ang="16200000" scaled="1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Feuil7!$B$11:$J$11</c:f>
                <c:numCache>
                  <c:formatCode>General</c:formatCode>
                  <c:ptCount val="9"/>
                  <c:pt idx="0">
                    <c:v>4.4738595691906045E-2</c:v>
                  </c:pt>
                  <c:pt idx="1">
                    <c:v>7.1493533336263751E-2</c:v>
                  </c:pt>
                  <c:pt idx="2">
                    <c:v>2.4903988824030958</c:v>
                  </c:pt>
                  <c:pt idx="3">
                    <c:v>0.8173904889654442</c:v>
                  </c:pt>
                  <c:pt idx="4">
                    <c:v>2.9839684302769887E-2</c:v>
                  </c:pt>
                  <c:pt idx="5">
                    <c:v>1.941355553715891E-2</c:v>
                  </c:pt>
                  <c:pt idx="6">
                    <c:v>1.0727478989226359E-2</c:v>
                  </c:pt>
                  <c:pt idx="7">
                    <c:v>1.3699130954064975</c:v>
                  </c:pt>
                  <c:pt idx="8">
                    <c:v>0.69550833870697992</c:v>
                  </c:pt>
                </c:numCache>
              </c:numRef>
            </c:plus>
            <c:minus>
              <c:numRef>
                <c:f>Feuil7!$B$11:$J$11</c:f>
                <c:numCache>
                  <c:formatCode>General</c:formatCode>
                  <c:ptCount val="9"/>
                  <c:pt idx="0">
                    <c:v>4.4738595691906045E-2</c:v>
                  </c:pt>
                  <c:pt idx="1">
                    <c:v>7.1493533336263751E-2</c:v>
                  </c:pt>
                  <c:pt idx="2">
                    <c:v>2.4903988824030958</c:v>
                  </c:pt>
                  <c:pt idx="3">
                    <c:v>0.8173904889654442</c:v>
                  </c:pt>
                  <c:pt idx="4">
                    <c:v>2.9839684302769887E-2</c:v>
                  </c:pt>
                  <c:pt idx="5">
                    <c:v>1.941355553715891E-2</c:v>
                  </c:pt>
                  <c:pt idx="6">
                    <c:v>1.0727478989226359E-2</c:v>
                  </c:pt>
                  <c:pt idx="7">
                    <c:v>1.3699130954064975</c:v>
                  </c:pt>
                  <c:pt idx="8">
                    <c:v>0.69550833870697992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Feuil7!$B$1:$J$1</c:f>
              <c:strCache>
                <c:ptCount val="9"/>
                <c:pt idx="0">
                  <c:v>41</c:v>
                </c:pt>
                <c:pt idx="1">
                  <c:v>41.4</c:v>
                </c:pt>
                <c:pt idx="2">
                  <c:v>41.5A</c:v>
                </c:pt>
                <c:pt idx="3">
                  <c:v>41.5B</c:v>
                </c:pt>
                <c:pt idx="4">
                  <c:v>41.5C</c:v>
                </c:pt>
                <c:pt idx="5">
                  <c:v>41.5D</c:v>
                </c:pt>
                <c:pt idx="6">
                  <c:v>41.5E</c:v>
                </c:pt>
                <c:pt idx="7">
                  <c:v>41.5F</c:v>
                </c:pt>
                <c:pt idx="8">
                  <c:v>41.5G</c:v>
                </c:pt>
              </c:strCache>
            </c:strRef>
          </c:cat>
          <c:val>
            <c:numRef>
              <c:f>Feuil7!$B$10:$J$10</c:f>
              <c:numCache>
                <c:formatCode>0.000</c:formatCode>
                <c:ptCount val="9"/>
                <c:pt idx="0">
                  <c:v>7.7397980826477961E-2</c:v>
                </c:pt>
                <c:pt idx="1">
                  <c:v>0.10890702506769551</c:v>
                </c:pt>
                <c:pt idx="2">
                  <c:v>5.7639075136206976</c:v>
                </c:pt>
                <c:pt idx="3">
                  <c:v>1.7510818206185463</c:v>
                </c:pt>
                <c:pt idx="4">
                  <c:v>6.1198751747317835E-2</c:v>
                </c:pt>
                <c:pt idx="5">
                  <c:v>2.9120462901311994E-2</c:v>
                </c:pt>
                <c:pt idx="6">
                  <c:v>1.6091540518604248E-2</c:v>
                </c:pt>
                <c:pt idx="7">
                  <c:v>3.4918690987378067</c:v>
                </c:pt>
                <c:pt idx="8">
                  <c:v>2.18904859065701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FF3-4386-8D84-2FC13FE0BF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-144760448"/>
        <c:axId val="-144752288"/>
      </c:barChart>
      <c:catAx>
        <c:axId val="-1447604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752288"/>
        <c:crosses val="autoZero"/>
        <c:auto val="1"/>
        <c:lblAlgn val="ctr"/>
        <c:lblOffset val="100"/>
        <c:noMultiLvlLbl val="0"/>
      </c:catAx>
      <c:valAx>
        <c:axId val="-144752288"/>
        <c:scaling>
          <c:orientation val="minMax"/>
        </c:scaling>
        <c:delete val="0"/>
        <c:axPos val="l"/>
        <c:numFmt formatCode="#,##0.00" sourceLinked="0"/>
        <c:majorTickMark val="none"/>
        <c:minorTickMark val="none"/>
        <c:tickLblPos val="nextTo"/>
        <c:spPr>
          <a:noFill/>
          <a:ln>
            <a:solidFill>
              <a:sysClr val="window" lastClr="FFFFFF">
                <a:lumMod val="85000"/>
              </a:sys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7604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7!$A$12</c:f>
              <c:strCache>
                <c:ptCount val="1"/>
                <c:pt idx="0">
                  <c:v>LY6D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tint val="50000"/>
                    <a:satMod val="300000"/>
                  </a:schemeClr>
                </a:gs>
                <a:gs pos="35000">
                  <a:schemeClr val="dk1">
                    <a:tint val="88500"/>
                    <a:tint val="37000"/>
                    <a:satMod val="300000"/>
                  </a:schemeClr>
                </a:gs>
                <a:gs pos="100000">
                  <a:schemeClr val="dk1">
                    <a:tint val="88500"/>
                    <a:tint val="15000"/>
                    <a:satMod val="350000"/>
                  </a:schemeClr>
                </a:gs>
              </a:gsLst>
              <a:lin ang="16200000" scaled="1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Feuil7!$B$13:$J$13</c:f>
                <c:numCache>
                  <c:formatCode>General</c:formatCode>
                  <c:ptCount val="9"/>
                  <c:pt idx="0">
                    <c:v>5.0399731101843682E-2</c:v>
                  </c:pt>
                  <c:pt idx="1">
                    <c:v>3.6246894258550095</c:v>
                  </c:pt>
                  <c:pt idx="2">
                    <c:v>6.0194267919646594</c:v>
                  </c:pt>
                  <c:pt idx="3">
                    <c:v>4.245422708757177</c:v>
                  </c:pt>
                  <c:pt idx="4">
                    <c:v>0.13019436191302866</c:v>
                  </c:pt>
                  <c:pt idx="5">
                    <c:v>6.1687085032732736E-2</c:v>
                  </c:pt>
                  <c:pt idx="6">
                    <c:v>5.0342366708490828E-2</c:v>
                  </c:pt>
                  <c:pt idx="7">
                    <c:v>1.6666244026088901</c:v>
                  </c:pt>
                  <c:pt idx="8">
                    <c:v>6.0531055239734792</c:v>
                  </c:pt>
                </c:numCache>
              </c:numRef>
            </c:plus>
            <c:minus>
              <c:numRef>
                <c:f>Feuil7!$B$13:$J$13</c:f>
                <c:numCache>
                  <c:formatCode>General</c:formatCode>
                  <c:ptCount val="9"/>
                  <c:pt idx="0">
                    <c:v>5.0399731101843682E-2</c:v>
                  </c:pt>
                  <c:pt idx="1">
                    <c:v>3.6246894258550095</c:v>
                  </c:pt>
                  <c:pt idx="2">
                    <c:v>6.0194267919646594</c:v>
                  </c:pt>
                  <c:pt idx="3">
                    <c:v>4.245422708757177</c:v>
                  </c:pt>
                  <c:pt idx="4">
                    <c:v>0.13019436191302866</c:v>
                  </c:pt>
                  <c:pt idx="5">
                    <c:v>6.1687085032732736E-2</c:v>
                  </c:pt>
                  <c:pt idx="6">
                    <c:v>5.0342366708490828E-2</c:v>
                  </c:pt>
                  <c:pt idx="7">
                    <c:v>1.6666244026088901</c:v>
                  </c:pt>
                  <c:pt idx="8">
                    <c:v>6.0531055239734792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Feuil7!$B$1:$J$1</c:f>
              <c:strCache>
                <c:ptCount val="9"/>
                <c:pt idx="0">
                  <c:v>41</c:v>
                </c:pt>
                <c:pt idx="1">
                  <c:v>41.4</c:v>
                </c:pt>
                <c:pt idx="2">
                  <c:v>41.5A</c:v>
                </c:pt>
                <c:pt idx="3">
                  <c:v>41.5B</c:v>
                </c:pt>
                <c:pt idx="4">
                  <c:v>41.5C</c:v>
                </c:pt>
                <c:pt idx="5">
                  <c:v>41.5D</c:v>
                </c:pt>
                <c:pt idx="6">
                  <c:v>41.5E</c:v>
                </c:pt>
                <c:pt idx="7">
                  <c:v>41.5F</c:v>
                </c:pt>
                <c:pt idx="8">
                  <c:v>41.5G</c:v>
                </c:pt>
              </c:strCache>
            </c:strRef>
          </c:cat>
          <c:val>
            <c:numRef>
              <c:f>Feuil7!$B$12:$J$12</c:f>
              <c:numCache>
                <c:formatCode>0.000</c:formatCode>
                <c:ptCount val="9"/>
                <c:pt idx="0">
                  <c:v>6.4052247340989188E-2</c:v>
                </c:pt>
                <c:pt idx="1">
                  <c:v>9.1877492045362903</c:v>
                </c:pt>
                <c:pt idx="2">
                  <c:v>16.324917809373215</c:v>
                </c:pt>
                <c:pt idx="3">
                  <c:v>13.331891076462066</c:v>
                </c:pt>
                <c:pt idx="4">
                  <c:v>0.46278832628802774</c:v>
                </c:pt>
                <c:pt idx="5">
                  <c:v>0.21106121135417152</c:v>
                </c:pt>
                <c:pt idx="6">
                  <c:v>9.7760486760232398E-2</c:v>
                </c:pt>
                <c:pt idx="7">
                  <c:v>4.7720704768232176</c:v>
                </c:pt>
                <c:pt idx="8">
                  <c:v>16.2122719660861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96C-45B9-9D66-AFEC0AE75F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-144746848"/>
        <c:axId val="-144759904"/>
      </c:barChart>
      <c:catAx>
        <c:axId val="-1447468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759904"/>
        <c:crosses val="autoZero"/>
        <c:auto val="1"/>
        <c:lblAlgn val="ctr"/>
        <c:lblOffset val="100"/>
        <c:noMultiLvlLbl val="0"/>
      </c:catAx>
      <c:valAx>
        <c:axId val="-144759904"/>
        <c:scaling>
          <c:orientation val="minMax"/>
        </c:scaling>
        <c:delete val="0"/>
        <c:axPos val="l"/>
        <c:numFmt formatCode="#,##0.00" sourceLinked="0"/>
        <c:majorTickMark val="none"/>
        <c:minorTickMark val="none"/>
        <c:tickLblPos val="nextTo"/>
        <c:spPr>
          <a:noFill/>
          <a:ln>
            <a:solidFill>
              <a:sysClr val="window" lastClr="FFFFFF">
                <a:lumMod val="85000"/>
              </a:sys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7468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4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7!$A$14</c:f>
              <c:strCache>
                <c:ptCount val="1"/>
                <c:pt idx="0">
                  <c:v>KRT6B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tint val="50000"/>
                    <a:satMod val="300000"/>
                  </a:schemeClr>
                </a:gs>
                <a:gs pos="35000">
                  <a:schemeClr val="dk1">
                    <a:tint val="88500"/>
                    <a:tint val="37000"/>
                    <a:satMod val="300000"/>
                  </a:schemeClr>
                </a:gs>
                <a:gs pos="100000">
                  <a:schemeClr val="dk1">
                    <a:tint val="88500"/>
                    <a:tint val="15000"/>
                    <a:satMod val="350000"/>
                  </a:schemeClr>
                </a:gs>
              </a:gsLst>
              <a:lin ang="16200000" scaled="1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Feuil7!$B$15:$J$15</c:f>
                <c:numCache>
                  <c:formatCode>General</c:formatCode>
                  <c:ptCount val="9"/>
                  <c:pt idx="0">
                    <c:v>7.0186387479620447E-8</c:v>
                  </c:pt>
                  <c:pt idx="1">
                    <c:v>0.75063012869046686</c:v>
                  </c:pt>
                  <c:pt idx="2">
                    <c:v>16.21829239191775</c:v>
                  </c:pt>
                  <c:pt idx="3">
                    <c:v>3.6435863387969754</c:v>
                  </c:pt>
                  <c:pt idx="4">
                    <c:v>5.491502168952577E-8</c:v>
                  </c:pt>
                  <c:pt idx="5">
                    <c:v>9.6267084085805044E-8</c:v>
                  </c:pt>
                  <c:pt idx="6">
                    <c:v>6.7489163700162145E-8</c:v>
                  </c:pt>
                  <c:pt idx="7">
                    <c:v>9.881571135777488</c:v>
                  </c:pt>
                  <c:pt idx="8">
                    <c:v>5.7563942390989489</c:v>
                  </c:pt>
                </c:numCache>
              </c:numRef>
            </c:plus>
            <c:minus>
              <c:numRef>
                <c:f>Feuil7!$B$15:$J$15</c:f>
                <c:numCache>
                  <c:formatCode>General</c:formatCode>
                  <c:ptCount val="9"/>
                  <c:pt idx="0">
                    <c:v>7.0186387479620447E-8</c:v>
                  </c:pt>
                  <c:pt idx="1">
                    <c:v>0.75063012869046686</c:v>
                  </c:pt>
                  <c:pt idx="2">
                    <c:v>16.21829239191775</c:v>
                  </c:pt>
                  <c:pt idx="3">
                    <c:v>3.6435863387969754</c:v>
                  </c:pt>
                  <c:pt idx="4">
                    <c:v>5.491502168952577E-8</c:v>
                  </c:pt>
                  <c:pt idx="5">
                    <c:v>9.6267084085805044E-8</c:v>
                  </c:pt>
                  <c:pt idx="6">
                    <c:v>6.7489163700162145E-8</c:v>
                  </c:pt>
                  <c:pt idx="7">
                    <c:v>9.881571135777488</c:v>
                  </c:pt>
                  <c:pt idx="8">
                    <c:v>5.7563942390989489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Feuil7!$B$1:$J$1</c:f>
              <c:strCache>
                <c:ptCount val="9"/>
                <c:pt idx="0">
                  <c:v>41</c:v>
                </c:pt>
                <c:pt idx="1">
                  <c:v>41.4</c:v>
                </c:pt>
                <c:pt idx="2">
                  <c:v>41.5A</c:v>
                </c:pt>
                <c:pt idx="3">
                  <c:v>41.5B</c:v>
                </c:pt>
                <c:pt idx="4">
                  <c:v>41.5C</c:v>
                </c:pt>
                <c:pt idx="5">
                  <c:v>41.5D</c:v>
                </c:pt>
                <c:pt idx="6">
                  <c:v>41.5E</c:v>
                </c:pt>
                <c:pt idx="7">
                  <c:v>41.5F</c:v>
                </c:pt>
                <c:pt idx="8">
                  <c:v>41.5G</c:v>
                </c:pt>
              </c:strCache>
            </c:strRef>
          </c:cat>
          <c:val>
            <c:numRef>
              <c:f>Feuil7!$B$14:$J$14</c:f>
              <c:numCache>
                <c:formatCode>0.000</c:formatCode>
                <c:ptCount val="9"/>
                <c:pt idx="0">
                  <c:v>2.6452895156179371E-7</c:v>
                </c:pt>
                <c:pt idx="1">
                  <c:v>2.1034027786552438</c:v>
                </c:pt>
                <c:pt idx="2">
                  <c:v>40.252606543834574</c:v>
                </c:pt>
                <c:pt idx="3">
                  <c:v>9.0805678371983287</c:v>
                </c:pt>
                <c:pt idx="4">
                  <c:v>3.0319395238337605E-7</c:v>
                </c:pt>
                <c:pt idx="5">
                  <c:v>2.3703133348150942E-7</c:v>
                </c:pt>
                <c:pt idx="6">
                  <c:v>2.6703650609955492E-7</c:v>
                </c:pt>
                <c:pt idx="7">
                  <c:v>22.234176828454604</c:v>
                </c:pt>
                <c:pt idx="8">
                  <c:v>15.037967016072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847-4C17-85E5-DB03183725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-144747392"/>
        <c:axId val="-144756640"/>
      </c:barChart>
      <c:catAx>
        <c:axId val="-1447473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756640"/>
        <c:crosses val="autoZero"/>
        <c:auto val="1"/>
        <c:lblAlgn val="ctr"/>
        <c:lblOffset val="100"/>
        <c:noMultiLvlLbl val="0"/>
      </c:catAx>
      <c:valAx>
        <c:axId val="-144756640"/>
        <c:scaling>
          <c:orientation val="minMax"/>
        </c:scaling>
        <c:delete val="0"/>
        <c:axPos val="l"/>
        <c:numFmt formatCode="#,##0.00" sourceLinked="0"/>
        <c:majorTickMark val="none"/>
        <c:minorTickMark val="none"/>
        <c:tickLblPos val="nextTo"/>
        <c:spPr>
          <a:noFill/>
          <a:ln>
            <a:solidFill>
              <a:sysClr val="window" lastClr="FFFFFF">
                <a:lumMod val="85000"/>
              </a:sys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7473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4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7!$A$16</c:f>
              <c:strCache>
                <c:ptCount val="1"/>
                <c:pt idx="0">
                  <c:v>DEFA5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tint val="50000"/>
                    <a:satMod val="300000"/>
                  </a:schemeClr>
                </a:gs>
                <a:gs pos="35000">
                  <a:schemeClr val="dk1">
                    <a:tint val="88500"/>
                    <a:tint val="37000"/>
                    <a:satMod val="300000"/>
                  </a:schemeClr>
                </a:gs>
                <a:gs pos="100000">
                  <a:schemeClr val="dk1">
                    <a:tint val="88500"/>
                    <a:tint val="15000"/>
                    <a:satMod val="350000"/>
                  </a:schemeClr>
                </a:gs>
              </a:gsLst>
              <a:lin ang="16200000" scaled="1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Feuil7!$B$17:$J$17</c:f>
                <c:numCache>
                  <c:formatCode>General</c:formatCode>
                  <c:ptCount val="9"/>
                  <c:pt idx="0">
                    <c:v>14.38810600360573</c:v>
                  </c:pt>
                  <c:pt idx="1">
                    <c:v>0.32963282694353319</c:v>
                  </c:pt>
                  <c:pt idx="2">
                    <c:v>1.3084431274212339E-7</c:v>
                  </c:pt>
                  <c:pt idx="3">
                    <c:v>1.5697632548486705E-7</c:v>
                  </c:pt>
                  <c:pt idx="4">
                    <c:v>6.3721653441824593</c:v>
                  </c:pt>
                  <c:pt idx="5">
                    <c:v>0.88630663290980261</c:v>
                  </c:pt>
                  <c:pt idx="6">
                    <c:v>0.17805192518598614</c:v>
                  </c:pt>
                  <c:pt idx="7">
                    <c:v>1.0335552521703816E-7</c:v>
                  </c:pt>
                  <c:pt idx="8">
                    <c:v>1.6682157127453922E-7</c:v>
                  </c:pt>
                </c:numCache>
              </c:numRef>
            </c:plus>
            <c:minus>
              <c:numRef>
                <c:f>Feuil7!$B$17:$J$17</c:f>
                <c:numCache>
                  <c:formatCode>General</c:formatCode>
                  <c:ptCount val="9"/>
                  <c:pt idx="0">
                    <c:v>14.38810600360573</c:v>
                  </c:pt>
                  <c:pt idx="1">
                    <c:v>0.32963282694353319</c:v>
                  </c:pt>
                  <c:pt idx="2">
                    <c:v>1.3084431274212339E-7</c:v>
                  </c:pt>
                  <c:pt idx="3">
                    <c:v>1.5697632548486705E-7</c:v>
                  </c:pt>
                  <c:pt idx="4">
                    <c:v>6.3721653441824593</c:v>
                  </c:pt>
                  <c:pt idx="5">
                    <c:v>0.88630663290980261</c:v>
                  </c:pt>
                  <c:pt idx="6">
                    <c:v>0.17805192518598614</c:v>
                  </c:pt>
                  <c:pt idx="7">
                    <c:v>1.0335552521703816E-7</c:v>
                  </c:pt>
                  <c:pt idx="8">
                    <c:v>1.6682157127453922E-7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Feuil7!$B$1:$J$1</c:f>
              <c:strCache>
                <c:ptCount val="9"/>
                <c:pt idx="0">
                  <c:v>41</c:v>
                </c:pt>
                <c:pt idx="1">
                  <c:v>41.4</c:v>
                </c:pt>
                <c:pt idx="2">
                  <c:v>41.5A</c:v>
                </c:pt>
                <c:pt idx="3">
                  <c:v>41.5B</c:v>
                </c:pt>
                <c:pt idx="4">
                  <c:v>41.5C</c:v>
                </c:pt>
                <c:pt idx="5">
                  <c:v>41.5D</c:v>
                </c:pt>
                <c:pt idx="6">
                  <c:v>41.5E</c:v>
                </c:pt>
                <c:pt idx="7">
                  <c:v>41.5F</c:v>
                </c:pt>
                <c:pt idx="8">
                  <c:v>41.5G</c:v>
                </c:pt>
              </c:strCache>
            </c:strRef>
          </c:cat>
          <c:val>
            <c:numRef>
              <c:f>Feuil7!$B$16:$J$16</c:f>
              <c:numCache>
                <c:formatCode>0.000</c:formatCode>
                <c:ptCount val="9"/>
                <c:pt idx="0">
                  <c:v>47.776730734307286</c:v>
                </c:pt>
                <c:pt idx="1">
                  <c:v>0.24722487990560324</c:v>
                </c:pt>
                <c:pt idx="2">
                  <c:v>5.3644824957660134E-7</c:v>
                </c:pt>
                <c:pt idx="3">
                  <c:v>5.6475906129597302E-7</c:v>
                </c:pt>
                <c:pt idx="4">
                  <c:v>41.193131017192577</c:v>
                </c:pt>
                <c:pt idx="5">
                  <c:v>4.8487185238494117</c:v>
                </c:pt>
                <c:pt idx="6">
                  <c:v>0.13353926154286849</c:v>
                </c:pt>
                <c:pt idx="7">
                  <c:v>5.5308974360176376E-7</c:v>
                </c:pt>
                <c:pt idx="8">
                  <c:v>6.1953618624939957E-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316-4229-8F63-0117502C0C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-144753376"/>
        <c:axId val="-144752832"/>
      </c:barChart>
      <c:catAx>
        <c:axId val="-1447533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752832"/>
        <c:crosses val="autoZero"/>
        <c:auto val="1"/>
        <c:lblAlgn val="ctr"/>
        <c:lblOffset val="100"/>
        <c:noMultiLvlLbl val="0"/>
      </c:catAx>
      <c:valAx>
        <c:axId val="-144752832"/>
        <c:scaling>
          <c:orientation val="minMax"/>
        </c:scaling>
        <c:delete val="0"/>
        <c:axPos val="l"/>
        <c:numFmt formatCode="#,##0.00" sourceLinked="0"/>
        <c:majorTickMark val="none"/>
        <c:minorTickMark val="none"/>
        <c:tickLblPos val="nextTo"/>
        <c:spPr>
          <a:noFill/>
          <a:ln>
            <a:solidFill>
              <a:sysClr val="window" lastClr="FFFFFF">
                <a:lumMod val="85000"/>
              </a:sys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7533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4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7!$A$18</c:f>
              <c:strCache>
                <c:ptCount val="1"/>
                <c:pt idx="0">
                  <c:v>DEFA6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tint val="50000"/>
                    <a:satMod val="300000"/>
                  </a:schemeClr>
                </a:gs>
                <a:gs pos="35000">
                  <a:schemeClr val="dk1">
                    <a:tint val="88500"/>
                    <a:tint val="37000"/>
                    <a:satMod val="300000"/>
                  </a:schemeClr>
                </a:gs>
                <a:gs pos="100000">
                  <a:schemeClr val="dk1">
                    <a:tint val="88500"/>
                    <a:tint val="15000"/>
                    <a:satMod val="350000"/>
                  </a:schemeClr>
                </a:gs>
              </a:gsLst>
              <a:lin ang="16200000" scaled="1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Feuil7!$B$19:$J$19</c:f>
                <c:numCache>
                  <c:formatCode>General</c:formatCode>
                  <c:ptCount val="9"/>
                  <c:pt idx="0">
                    <c:v>34.86142720100829</c:v>
                  </c:pt>
                  <c:pt idx="1">
                    <c:v>3.6955996384025656E-2</c:v>
                  </c:pt>
                  <c:pt idx="2">
                    <c:v>2.4587611079972111E-2</c:v>
                  </c:pt>
                  <c:pt idx="3">
                    <c:v>4.0555358609109617E-2</c:v>
                  </c:pt>
                  <c:pt idx="4">
                    <c:v>14.695369630111722</c:v>
                  </c:pt>
                  <c:pt idx="5">
                    <c:v>3.0924935845448132</c:v>
                  </c:pt>
                  <c:pt idx="6">
                    <c:v>5.6923486693365097E-2</c:v>
                  </c:pt>
                  <c:pt idx="7">
                    <c:v>7.3270504234163511E-8</c:v>
                  </c:pt>
                  <c:pt idx="8">
                    <c:v>7.7581109801757794E-2</c:v>
                  </c:pt>
                </c:numCache>
              </c:numRef>
            </c:plus>
            <c:minus>
              <c:numRef>
                <c:f>Feuil7!$B$19:$J$19</c:f>
                <c:numCache>
                  <c:formatCode>General</c:formatCode>
                  <c:ptCount val="9"/>
                  <c:pt idx="0">
                    <c:v>34.86142720100829</c:v>
                  </c:pt>
                  <c:pt idx="1">
                    <c:v>3.6955996384025656E-2</c:v>
                  </c:pt>
                  <c:pt idx="2">
                    <c:v>2.4587611079972111E-2</c:v>
                  </c:pt>
                  <c:pt idx="3">
                    <c:v>4.0555358609109617E-2</c:v>
                  </c:pt>
                  <c:pt idx="4">
                    <c:v>14.695369630111722</c:v>
                  </c:pt>
                  <c:pt idx="5">
                    <c:v>3.0924935845448132</c:v>
                  </c:pt>
                  <c:pt idx="6">
                    <c:v>5.6923486693365097E-2</c:v>
                  </c:pt>
                  <c:pt idx="7">
                    <c:v>7.3270504234163511E-8</c:v>
                  </c:pt>
                  <c:pt idx="8">
                    <c:v>7.7581109801757794E-2</c:v>
                  </c:pt>
                </c:numCache>
              </c:numRef>
            </c:minus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errBars>
          <c:cat>
            <c:strRef>
              <c:f>Feuil7!$B$1:$J$1</c:f>
              <c:strCache>
                <c:ptCount val="9"/>
                <c:pt idx="0">
                  <c:v>41</c:v>
                </c:pt>
                <c:pt idx="1">
                  <c:v>41.4</c:v>
                </c:pt>
                <c:pt idx="2">
                  <c:v>41.5A</c:v>
                </c:pt>
                <c:pt idx="3">
                  <c:v>41.5B</c:v>
                </c:pt>
                <c:pt idx="4">
                  <c:v>41.5C</c:v>
                </c:pt>
                <c:pt idx="5">
                  <c:v>41.5D</c:v>
                </c:pt>
                <c:pt idx="6">
                  <c:v>41.5E</c:v>
                </c:pt>
                <c:pt idx="7">
                  <c:v>41.5F</c:v>
                </c:pt>
                <c:pt idx="8">
                  <c:v>41.5G</c:v>
                </c:pt>
              </c:strCache>
            </c:strRef>
          </c:cat>
          <c:val>
            <c:numRef>
              <c:f>Feuil7!$B$18:$J$18</c:f>
              <c:numCache>
                <c:formatCode>0.000</c:formatCode>
                <c:ptCount val="9"/>
                <c:pt idx="0">
                  <c:v>138.76649492572605</c:v>
                </c:pt>
                <c:pt idx="1">
                  <c:v>0.14948059742715966</c:v>
                </c:pt>
                <c:pt idx="2">
                  <c:v>3.688234148966172E-2</c:v>
                </c:pt>
                <c:pt idx="3">
                  <c:v>6.083365347276537E-2</c:v>
                </c:pt>
                <c:pt idx="4">
                  <c:v>89.520888943349135</c:v>
                </c:pt>
                <c:pt idx="5">
                  <c:v>13.357107229919855</c:v>
                </c:pt>
                <c:pt idx="6">
                  <c:v>0.47369278126648195</c:v>
                </c:pt>
                <c:pt idx="7">
                  <c:v>5.8121199167605016E-7</c:v>
                </c:pt>
                <c:pt idx="8">
                  <c:v>5.818643903950467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6D9-4A25-BAA3-CE8BC23A5C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-144751744"/>
        <c:axId val="-144751200"/>
      </c:barChart>
      <c:catAx>
        <c:axId val="-1447517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751200"/>
        <c:crosses val="autoZero"/>
        <c:auto val="1"/>
        <c:lblAlgn val="ctr"/>
        <c:lblOffset val="100"/>
        <c:noMultiLvlLbl val="0"/>
      </c:catAx>
      <c:valAx>
        <c:axId val="-144751200"/>
        <c:scaling>
          <c:orientation val="minMax"/>
        </c:scaling>
        <c:delete val="0"/>
        <c:axPos val="l"/>
        <c:numFmt formatCode="#,##0.00" sourceLinked="0"/>
        <c:majorTickMark val="none"/>
        <c:minorTickMark val="none"/>
        <c:tickLblPos val="nextTo"/>
        <c:spPr>
          <a:noFill/>
          <a:ln>
            <a:solidFill>
              <a:sysClr val="window" lastClr="FFFFFF">
                <a:lumMod val="85000"/>
              </a:sys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7517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10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11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12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13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14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15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16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7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8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9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454468" y="2300585"/>
            <a:ext cx="16483965" cy="4894027"/>
          </a:xfrm>
        </p:spPr>
        <p:txBody>
          <a:bodyPr anchor="b"/>
          <a:lstStyle>
            <a:lvl1pPr algn="ctr">
              <a:defRPr sz="12299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424113" y="7383344"/>
            <a:ext cx="14544675" cy="3393929"/>
          </a:xfrm>
        </p:spPr>
        <p:txBody>
          <a:bodyPr/>
          <a:lstStyle>
            <a:lvl1pPr marL="0" indent="0" algn="ctr">
              <a:buNone/>
              <a:defRPr sz="4920"/>
            </a:lvl1pPr>
            <a:lvl2pPr marL="937169" indent="0" algn="ctr">
              <a:buNone/>
              <a:defRPr sz="4100"/>
            </a:lvl2pPr>
            <a:lvl3pPr marL="1874337" indent="0" algn="ctr">
              <a:buNone/>
              <a:defRPr sz="3690"/>
            </a:lvl3pPr>
            <a:lvl4pPr marL="2811506" indent="0" algn="ctr">
              <a:buNone/>
              <a:defRPr sz="3280"/>
            </a:lvl4pPr>
            <a:lvl5pPr marL="3748674" indent="0" algn="ctr">
              <a:buNone/>
              <a:defRPr sz="3280"/>
            </a:lvl5pPr>
            <a:lvl6pPr marL="4685843" indent="0" algn="ctr">
              <a:buNone/>
              <a:defRPr sz="3280"/>
            </a:lvl6pPr>
            <a:lvl7pPr marL="5623011" indent="0" algn="ctr">
              <a:buNone/>
              <a:defRPr sz="3280"/>
            </a:lvl7pPr>
            <a:lvl8pPr marL="6560180" indent="0" algn="ctr">
              <a:buNone/>
              <a:defRPr sz="3280"/>
            </a:lvl8pPr>
            <a:lvl9pPr marL="7497348" indent="0" algn="ctr">
              <a:buNone/>
              <a:defRPr sz="328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AA83D-3FE7-4E16-9544-F911E59DE200}" type="datetimeFigureOut">
              <a:rPr lang="fr-FR" smtClean="0"/>
              <a:t>07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18BF8-AC40-4033-B87D-4B4FD62A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68534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AA83D-3FE7-4E16-9544-F911E59DE200}" type="datetimeFigureOut">
              <a:rPr lang="fr-FR" smtClean="0"/>
              <a:t>07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18BF8-AC40-4033-B87D-4B4FD62A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30940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878045" y="748422"/>
            <a:ext cx="4181594" cy="11912923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33263" y="748422"/>
            <a:ext cx="12302371" cy="11912923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AA83D-3FE7-4E16-9544-F911E59DE200}" type="datetimeFigureOut">
              <a:rPr lang="fr-FR" smtClean="0"/>
              <a:t>07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18BF8-AC40-4033-B87D-4B4FD62A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54205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AA83D-3FE7-4E16-9544-F911E59DE200}" type="datetimeFigureOut">
              <a:rPr lang="fr-FR" smtClean="0"/>
              <a:t>07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18BF8-AC40-4033-B87D-4B4FD62A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5326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23163" y="3504570"/>
            <a:ext cx="16726376" cy="5847451"/>
          </a:xfrm>
        </p:spPr>
        <p:txBody>
          <a:bodyPr anchor="b"/>
          <a:lstStyle>
            <a:lvl1pPr>
              <a:defRPr sz="12299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23163" y="9407340"/>
            <a:ext cx="16726376" cy="3075036"/>
          </a:xfrm>
        </p:spPr>
        <p:txBody>
          <a:bodyPr/>
          <a:lstStyle>
            <a:lvl1pPr marL="0" indent="0">
              <a:buNone/>
              <a:defRPr sz="4920">
                <a:solidFill>
                  <a:schemeClr val="tx1"/>
                </a:solidFill>
              </a:defRPr>
            </a:lvl1pPr>
            <a:lvl2pPr marL="937169" indent="0">
              <a:buNone/>
              <a:defRPr sz="4100">
                <a:solidFill>
                  <a:schemeClr val="tx1">
                    <a:tint val="75000"/>
                  </a:schemeClr>
                </a:solidFill>
              </a:defRPr>
            </a:lvl2pPr>
            <a:lvl3pPr marL="1874337" indent="0">
              <a:buNone/>
              <a:defRPr sz="3690">
                <a:solidFill>
                  <a:schemeClr val="tx1">
                    <a:tint val="75000"/>
                  </a:schemeClr>
                </a:solidFill>
              </a:defRPr>
            </a:lvl3pPr>
            <a:lvl4pPr marL="2811506" indent="0">
              <a:buNone/>
              <a:defRPr sz="3280">
                <a:solidFill>
                  <a:schemeClr val="tx1">
                    <a:tint val="75000"/>
                  </a:schemeClr>
                </a:solidFill>
              </a:defRPr>
            </a:lvl4pPr>
            <a:lvl5pPr marL="3748674" indent="0">
              <a:buNone/>
              <a:defRPr sz="3280">
                <a:solidFill>
                  <a:schemeClr val="tx1">
                    <a:tint val="75000"/>
                  </a:schemeClr>
                </a:solidFill>
              </a:defRPr>
            </a:lvl5pPr>
            <a:lvl6pPr marL="4685843" indent="0">
              <a:buNone/>
              <a:defRPr sz="3280">
                <a:solidFill>
                  <a:schemeClr val="tx1">
                    <a:tint val="75000"/>
                  </a:schemeClr>
                </a:solidFill>
              </a:defRPr>
            </a:lvl6pPr>
            <a:lvl7pPr marL="5623011" indent="0">
              <a:buNone/>
              <a:defRPr sz="3280">
                <a:solidFill>
                  <a:schemeClr val="tx1">
                    <a:tint val="75000"/>
                  </a:schemeClr>
                </a:solidFill>
              </a:defRPr>
            </a:lvl7pPr>
            <a:lvl8pPr marL="6560180" indent="0">
              <a:buNone/>
              <a:defRPr sz="3280">
                <a:solidFill>
                  <a:schemeClr val="tx1">
                    <a:tint val="75000"/>
                  </a:schemeClr>
                </a:solidFill>
              </a:defRPr>
            </a:lvl8pPr>
            <a:lvl9pPr marL="7497348" indent="0">
              <a:buNone/>
              <a:defRPr sz="3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AA83D-3FE7-4E16-9544-F911E59DE200}" type="datetimeFigureOut">
              <a:rPr lang="fr-FR" smtClean="0"/>
              <a:t>07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18BF8-AC40-4033-B87D-4B4FD62A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45448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33262" y="3742109"/>
            <a:ext cx="8241983" cy="8919236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817655" y="3742109"/>
            <a:ext cx="8241983" cy="8919236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AA83D-3FE7-4E16-9544-F911E59DE200}" type="datetimeFigureOut">
              <a:rPr lang="fr-FR" smtClean="0"/>
              <a:t>07/08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18BF8-AC40-4033-B87D-4B4FD62A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66372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35788" y="748425"/>
            <a:ext cx="16726376" cy="271709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35790" y="3445995"/>
            <a:ext cx="8204104" cy="1688829"/>
          </a:xfrm>
        </p:spPr>
        <p:txBody>
          <a:bodyPr anchor="b"/>
          <a:lstStyle>
            <a:lvl1pPr marL="0" indent="0">
              <a:buNone/>
              <a:defRPr sz="4920" b="1"/>
            </a:lvl1pPr>
            <a:lvl2pPr marL="937169" indent="0">
              <a:buNone/>
              <a:defRPr sz="4100" b="1"/>
            </a:lvl2pPr>
            <a:lvl3pPr marL="1874337" indent="0">
              <a:buNone/>
              <a:defRPr sz="3690" b="1"/>
            </a:lvl3pPr>
            <a:lvl4pPr marL="2811506" indent="0">
              <a:buNone/>
              <a:defRPr sz="3280" b="1"/>
            </a:lvl4pPr>
            <a:lvl5pPr marL="3748674" indent="0">
              <a:buNone/>
              <a:defRPr sz="3280" b="1"/>
            </a:lvl5pPr>
            <a:lvl6pPr marL="4685843" indent="0">
              <a:buNone/>
              <a:defRPr sz="3280" b="1"/>
            </a:lvl6pPr>
            <a:lvl7pPr marL="5623011" indent="0">
              <a:buNone/>
              <a:defRPr sz="3280" b="1"/>
            </a:lvl7pPr>
            <a:lvl8pPr marL="6560180" indent="0">
              <a:buNone/>
              <a:defRPr sz="3280" b="1"/>
            </a:lvl8pPr>
            <a:lvl9pPr marL="7497348" indent="0">
              <a:buNone/>
              <a:defRPr sz="328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35790" y="5134824"/>
            <a:ext cx="8204104" cy="7552553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817657" y="3445995"/>
            <a:ext cx="8244508" cy="1688829"/>
          </a:xfrm>
        </p:spPr>
        <p:txBody>
          <a:bodyPr anchor="b"/>
          <a:lstStyle>
            <a:lvl1pPr marL="0" indent="0">
              <a:buNone/>
              <a:defRPr sz="4920" b="1"/>
            </a:lvl1pPr>
            <a:lvl2pPr marL="937169" indent="0">
              <a:buNone/>
              <a:defRPr sz="4100" b="1"/>
            </a:lvl2pPr>
            <a:lvl3pPr marL="1874337" indent="0">
              <a:buNone/>
              <a:defRPr sz="3690" b="1"/>
            </a:lvl3pPr>
            <a:lvl4pPr marL="2811506" indent="0">
              <a:buNone/>
              <a:defRPr sz="3280" b="1"/>
            </a:lvl4pPr>
            <a:lvl5pPr marL="3748674" indent="0">
              <a:buNone/>
              <a:defRPr sz="3280" b="1"/>
            </a:lvl5pPr>
            <a:lvl6pPr marL="4685843" indent="0">
              <a:buNone/>
              <a:defRPr sz="3280" b="1"/>
            </a:lvl6pPr>
            <a:lvl7pPr marL="5623011" indent="0">
              <a:buNone/>
              <a:defRPr sz="3280" b="1"/>
            </a:lvl7pPr>
            <a:lvl8pPr marL="6560180" indent="0">
              <a:buNone/>
              <a:defRPr sz="3280" b="1"/>
            </a:lvl8pPr>
            <a:lvl9pPr marL="7497348" indent="0">
              <a:buNone/>
              <a:defRPr sz="328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817657" y="5134824"/>
            <a:ext cx="8244508" cy="7552553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AA83D-3FE7-4E16-9544-F911E59DE200}" type="datetimeFigureOut">
              <a:rPr lang="fr-FR" smtClean="0"/>
              <a:t>07/08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18BF8-AC40-4033-B87D-4B4FD62A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74185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AA83D-3FE7-4E16-9544-F911E59DE200}" type="datetimeFigureOut">
              <a:rPr lang="fr-FR" smtClean="0"/>
              <a:t>07/08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18BF8-AC40-4033-B87D-4B4FD62A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523334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AA83D-3FE7-4E16-9544-F911E59DE200}" type="datetimeFigureOut">
              <a:rPr lang="fr-FR" smtClean="0"/>
              <a:t>07/08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18BF8-AC40-4033-B87D-4B4FD62A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0731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35788" y="937154"/>
            <a:ext cx="6254715" cy="3280040"/>
          </a:xfrm>
        </p:spPr>
        <p:txBody>
          <a:bodyPr anchor="b"/>
          <a:lstStyle>
            <a:lvl1pPr>
              <a:defRPr sz="6559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244508" y="2023996"/>
            <a:ext cx="9817656" cy="9989803"/>
          </a:xfrm>
        </p:spPr>
        <p:txBody>
          <a:bodyPr/>
          <a:lstStyle>
            <a:lvl1pPr>
              <a:defRPr sz="6559"/>
            </a:lvl1pPr>
            <a:lvl2pPr>
              <a:defRPr sz="5739"/>
            </a:lvl2pPr>
            <a:lvl3pPr>
              <a:defRPr sz="4920"/>
            </a:lvl3pPr>
            <a:lvl4pPr>
              <a:defRPr sz="4100"/>
            </a:lvl4pPr>
            <a:lvl5pPr>
              <a:defRPr sz="4100"/>
            </a:lvl5pPr>
            <a:lvl6pPr>
              <a:defRPr sz="4100"/>
            </a:lvl6pPr>
            <a:lvl7pPr>
              <a:defRPr sz="4100"/>
            </a:lvl7pPr>
            <a:lvl8pPr>
              <a:defRPr sz="4100"/>
            </a:lvl8pPr>
            <a:lvl9pPr>
              <a:defRPr sz="41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35788" y="4217194"/>
            <a:ext cx="6254715" cy="7812873"/>
          </a:xfrm>
        </p:spPr>
        <p:txBody>
          <a:bodyPr/>
          <a:lstStyle>
            <a:lvl1pPr marL="0" indent="0">
              <a:buNone/>
              <a:defRPr sz="3280"/>
            </a:lvl1pPr>
            <a:lvl2pPr marL="937169" indent="0">
              <a:buNone/>
              <a:defRPr sz="2870"/>
            </a:lvl2pPr>
            <a:lvl3pPr marL="1874337" indent="0">
              <a:buNone/>
              <a:defRPr sz="2460"/>
            </a:lvl3pPr>
            <a:lvl4pPr marL="2811506" indent="0">
              <a:buNone/>
              <a:defRPr sz="2050"/>
            </a:lvl4pPr>
            <a:lvl5pPr marL="3748674" indent="0">
              <a:buNone/>
              <a:defRPr sz="2050"/>
            </a:lvl5pPr>
            <a:lvl6pPr marL="4685843" indent="0">
              <a:buNone/>
              <a:defRPr sz="2050"/>
            </a:lvl6pPr>
            <a:lvl7pPr marL="5623011" indent="0">
              <a:buNone/>
              <a:defRPr sz="2050"/>
            </a:lvl7pPr>
            <a:lvl8pPr marL="6560180" indent="0">
              <a:buNone/>
              <a:defRPr sz="2050"/>
            </a:lvl8pPr>
            <a:lvl9pPr marL="7497348" indent="0">
              <a:buNone/>
              <a:defRPr sz="20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AA83D-3FE7-4E16-9544-F911E59DE200}" type="datetimeFigureOut">
              <a:rPr lang="fr-FR" smtClean="0"/>
              <a:t>07/08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18BF8-AC40-4033-B87D-4B4FD62A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9215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35788" y="937154"/>
            <a:ext cx="6254715" cy="3280040"/>
          </a:xfrm>
        </p:spPr>
        <p:txBody>
          <a:bodyPr anchor="b"/>
          <a:lstStyle>
            <a:lvl1pPr>
              <a:defRPr sz="6559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8244508" y="2023996"/>
            <a:ext cx="9817656" cy="9989803"/>
          </a:xfrm>
        </p:spPr>
        <p:txBody>
          <a:bodyPr anchor="t"/>
          <a:lstStyle>
            <a:lvl1pPr marL="0" indent="0">
              <a:buNone/>
              <a:defRPr sz="6559"/>
            </a:lvl1pPr>
            <a:lvl2pPr marL="937169" indent="0">
              <a:buNone/>
              <a:defRPr sz="5739"/>
            </a:lvl2pPr>
            <a:lvl3pPr marL="1874337" indent="0">
              <a:buNone/>
              <a:defRPr sz="4920"/>
            </a:lvl3pPr>
            <a:lvl4pPr marL="2811506" indent="0">
              <a:buNone/>
              <a:defRPr sz="4100"/>
            </a:lvl4pPr>
            <a:lvl5pPr marL="3748674" indent="0">
              <a:buNone/>
              <a:defRPr sz="4100"/>
            </a:lvl5pPr>
            <a:lvl6pPr marL="4685843" indent="0">
              <a:buNone/>
              <a:defRPr sz="4100"/>
            </a:lvl6pPr>
            <a:lvl7pPr marL="5623011" indent="0">
              <a:buNone/>
              <a:defRPr sz="4100"/>
            </a:lvl7pPr>
            <a:lvl8pPr marL="6560180" indent="0">
              <a:buNone/>
              <a:defRPr sz="4100"/>
            </a:lvl8pPr>
            <a:lvl9pPr marL="7497348" indent="0">
              <a:buNone/>
              <a:defRPr sz="41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35788" y="4217194"/>
            <a:ext cx="6254715" cy="7812873"/>
          </a:xfrm>
        </p:spPr>
        <p:txBody>
          <a:bodyPr/>
          <a:lstStyle>
            <a:lvl1pPr marL="0" indent="0">
              <a:buNone/>
              <a:defRPr sz="3280"/>
            </a:lvl1pPr>
            <a:lvl2pPr marL="937169" indent="0">
              <a:buNone/>
              <a:defRPr sz="2870"/>
            </a:lvl2pPr>
            <a:lvl3pPr marL="1874337" indent="0">
              <a:buNone/>
              <a:defRPr sz="2460"/>
            </a:lvl3pPr>
            <a:lvl4pPr marL="2811506" indent="0">
              <a:buNone/>
              <a:defRPr sz="2050"/>
            </a:lvl4pPr>
            <a:lvl5pPr marL="3748674" indent="0">
              <a:buNone/>
              <a:defRPr sz="2050"/>
            </a:lvl5pPr>
            <a:lvl6pPr marL="4685843" indent="0">
              <a:buNone/>
              <a:defRPr sz="2050"/>
            </a:lvl6pPr>
            <a:lvl7pPr marL="5623011" indent="0">
              <a:buNone/>
              <a:defRPr sz="2050"/>
            </a:lvl7pPr>
            <a:lvl8pPr marL="6560180" indent="0">
              <a:buNone/>
              <a:defRPr sz="2050"/>
            </a:lvl8pPr>
            <a:lvl9pPr marL="7497348" indent="0">
              <a:buNone/>
              <a:defRPr sz="20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AA83D-3FE7-4E16-9544-F911E59DE200}" type="datetimeFigureOut">
              <a:rPr lang="fr-FR" smtClean="0"/>
              <a:t>07/08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18BF8-AC40-4033-B87D-4B4FD62A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90458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333262" y="748425"/>
            <a:ext cx="16726376" cy="271709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33262" y="3742109"/>
            <a:ext cx="16726376" cy="89192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333262" y="13029050"/>
            <a:ext cx="4363403" cy="74842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9AA83D-3FE7-4E16-9544-F911E59DE200}" type="datetimeFigureOut">
              <a:rPr lang="fr-FR" smtClean="0"/>
              <a:t>07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423898" y="13029050"/>
            <a:ext cx="6545104" cy="74842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4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3696235" y="13029050"/>
            <a:ext cx="4363403" cy="74842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818BF8-AC40-4033-B87D-4B4FD62A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54617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74337" rtl="0" eaLnBrk="1" latinLnBrk="0" hangingPunct="1">
        <a:lnSpc>
          <a:spcPct val="90000"/>
        </a:lnSpc>
        <a:spcBef>
          <a:spcPct val="0"/>
        </a:spcBef>
        <a:buNone/>
        <a:defRPr sz="901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68584" indent="-468584" algn="l" defTabSz="1874337" rtl="0" eaLnBrk="1" latinLnBrk="0" hangingPunct="1">
        <a:lnSpc>
          <a:spcPct val="90000"/>
        </a:lnSpc>
        <a:spcBef>
          <a:spcPts val="2050"/>
        </a:spcBef>
        <a:buFont typeface="Arial" panose="020B0604020202020204" pitchFamily="34" charset="0"/>
        <a:buChar char="•"/>
        <a:defRPr sz="5739" kern="1200">
          <a:solidFill>
            <a:schemeClr val="tx1"/>
          </a:solidFill>
          <a:latin typeface="+mn-lt"/>
          <a:ea typeface="+mn-ea"/>
          <a:cs typeface="+mn-cs"/>
        </a:defRPr>
      </a:lvl1pPr>
      <a:lvl2pPr marL="1405753" indent="-468584" algn="l" defTabSz="1874337" rtl="0" eaLnBrk="1" latinLnBrk="0" hangingPunct="1">
        <a:lnSpc>
          <a:spcPct val="90000"/>
        </a:lnSpc>
        <a:spcBef>
          <a:spcPts val="1025"/>
        </a:spcBef>
        <a:buFont typeface="Arial" panose="020B0604020202020204" pitchFamily="34" charset="0"/>
        <a:buChar char="•"/>
        <a:defRPr sz="4920" kern="1200">
          <a:solidFill>
            <a:schemeClr val="tx1"/>
          </a:solidFill>
          <a:latin typeface="+mn-lt"/>
          <a:ea typeface="+mn-ea"/>
          <a:cs typeface="+mn-cs"/>
        </a:defRPr>
      </a:lvl2pPr>
      <a:lvl3pPr marL="2342921" indent="-468584" algn="l" defTabSz="1874337" rtl="0" eaLnBrk="1" latinLnBrk="0" hangingPunct="1">
        <a:lnSpc>
          <a:spcPct val="90000"/>
        </a:lnSpc>
        <a:spcBef>
          <a:spcPts val="1025"/>
        </a:spcBef>
        <a:buFont typeface="Arial" panose="020B0604020202020204" pitchFamily="34" charset="0"/>
        <a:buChar char="•"/>
        <a:defRPr sz="4100" kern="1200">
          <a:solidFill>
            <a:schemeClr val="tx1"/>
          </a:solidFill>
          <a:latin typeface="+mn-lt"/>
          <a:ea typeface="+mn-ea"/>
          <a:cs typeface="+mn-cs"/>
        </a:defRPr>
      </a:lvl3pPr>
      <a:lvl4pPr marL="3280090" indent="-468584" algn="l" defTabSz="1874337" rtl="0" eaLnBrk="1" latinLnBrk="0" hangingPunct="1">
        <a:lnSpc>
          <a:spcPct val="90000"/>
        </a:lnSpc>
        <a:spcBef>
          <a:spcPts val="1025"/>
        </a:spcBef>
        <a:buFont typeface="Arial" panose="020B0604020202020204" pitchFamily="34" charset="0"/>
        <a:buChar char="•"/>
        <a:defRPr sz="3690" kern="1200">
          <a:solidFill>
            <a:schemeClr val="tx1"/>
          </a:solidFill>
          <a:latin typeface="+mn-lt"/>
          <a:ea typeface="+mn-ea"/>
          <a:cs typeface="+mn-cs"/>
        </a:defRPr>
      </a:lvl4pPr>
      <a:lvl5pPr marL="4217259" indent="-468584" algn="l" defTabSz="1874337" rtl="0" eaLnBrk="1" latinLnBrk="0" hangingPunct="1">
        <a:lnSpc>
          <a:spcPct val="90000"/>
        </a:lnSpc>
        <a:spcBef>
          <a:spcPts val="1025"/>
        </a:spcBef>
        <a:buFont typeface="Arial" panose="020B0604020202020204" pitchFamily="34" charset="0"/>
        <a:buChar char="•"/>
        <a:defRPr sz="3690" kern="1200">
          <a:solidFill>
            <a:schemeClr val="tx1"/>
          </a:solidFill>
          <a:latin typeface="+mn-lt"/>
          <a:ea typeface="+mn-ea"/>
          <a:cs typeface="+mn-cs"/>
        </a:defRPr>
      </a:lvl5pPr>
      <a:lvl6pPr marL="5154427" indent="-468584" algn="l" defTabSz="1874337" rtl="0" eaLnBrk="1" latinLnBrk="0" hangingPunct="1">
        <a:lnSpc>
          <a:spcPct val="90000"/>
        </a:lnSpc>
        <a:spcBef>
          <a:spcPts val="1025"/>
        </a:spcBef>
        <a:buFont typeface="Arial" panose="020B0604020202020204" pitchFamily="34" charset="0"/>
        <a:buChar char="•"/>
        <a:defRPr sz="3690" kern="1200">
          <a:solidFill>
            <a:schemeClr val="tx1"/>
          </a:solidFill>
          <a:latin typeface="+mn-lt"/>
          <a:ea typeface="+mn-ea"/>
          <a:cs typeface="+mn-cs"/>
        </a:defRPr>
      </a:lvl6pPr>
      <a:lvl7pPr marL="6091596" indent="-468584" algn="l" defTabSz="1874337" rtl="0" eaLnBrk="1" latinLnBrk="0" hangingPunct="1">
        <a:lnSpc>
          <a:spcPct val="90000"/>
        </a:lnSpc>
        <a:spcBef>
          <a:spcPts val="1025"/>
        </a:spcBef>
        <a:buFont typeface="Arial" panose="020B0604020202020204" pitchFamily="34" charset="0"/>
        <a:buChar char="•"/>
        <a:defRPr sz="3690" kern="1200">
          <a:solidFill>
            <a:schemeClr val="tx1"/>
          </a:solidFill>
          <a:latin typeface="+mn-lt"/>
          <a:ea typeface="+mn-ea"/>
          <a:cs typeface="+mn-cs"/>
        </a:defRPr>
      </a:lvl7pPr>
      <a:lvl8pPr marL="7028764" indent="-468584" algn="l" defTabSz="1874337" rtl="0" eaLnBrk="1" latinLnBrk="0" hangingPunct="1">
        <a:lnSpc>
          <a:spcPct val="90000"/>
        </a:lnSpc>
        <a:spcBef>
          <a:spcPts val="1025"/>
        </a:spcBef>
        <a:buFont typeface="Arial" panose="020B0604020202020204" pitchFamily="34" charset="0"/>
        <a:buChar char="•"/>
        <a:defRPr sz="3690" kern="1200">
          <a:solidFill>
            <a:schemeClr val="tx1"/>
          </a:solidFill>
          <a:latin typeface="+mn-lt"/>
          <a:ea typeface="+mn-ea"/>
          <a:cs typeface="+mn-cs"/>
        </a:defRPr>
      </a:lvl8pPr>
      <a:lvl9pPr marL="7965933" indent="-468584" algn="l" defTabSz="1874337" rtl="0" eaLnBrk="1" latinLnBrk="0" hangingPunct="1">
        <a:lnSpc>
          <a:spcPct val="90000"/>
        </a:lnSpc>
        <a:spcBef>
          <a:spcPts val="1025"/>
        </a:spcBef>
        <a:buFont typeface="Arial" panose="020B0604020202020204" pitchFamily="34" charset="0"/>
        <a:buChar char="•"/>
        <a:defRPr sz="36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74337" rtl="0" eaLnBrk="1" latinLnBrk="0" hangingPunct="1">
        <a:defRPr sz="3690" kern="1200">
          <a:solidFill>
            <a:schemeClr val="tx1"/>
          </a:solidFill>
          <a:latin typeface="+mn-lt"/>
          <a:ea typeface="+mn-ea"/>
          <a:cs typeface="+mn-cs"/>
        </a:defRPr>
      </a:lvl1pPr>
      <a:lvl2pPr marL="937169" algn="l" defTabSz="1874337" rtl="0" eaLnBrk="1" latinLnBrk="0" hangingPunct="1">
        <a:defRPr sz="3690" kern="1200">
          <a:solidFill>
            <a:schemeClr val="tx1"/>
          </a:solidFill>
          <a:latin typeface="+mn-lt"/>
          <a:ea typeface="+mn-ea"/>
          <a:cs typeface="+mn-cs"/>
        </a:defRPr>
      </a:lvl2pPr>
      <a:lvl3pPr marL="1874337" algn="l" defTabSz="1874337" rtl="0" eaLnBrk="1" latinLnBrk="0" hangingPunct="1">
        <a:defRPr sz="3690" kern="1200">
          <a:solidFill>
            <a:schemeClr val="tx1"/>
          </a:solidFill>
          <a:latin typeface="+mn-lt"/>
          <a:ea typeface="+mn-ea"/>
          <a:cs typeface="+mn-cs"/>
        </a:defRPr>
      </a:lvl3pPr>
      <a:lvl4pPr marL="2811506" algn="l" defTabSz="1874337" rtl="0" eaLnBrk="1" latinLnBrk="0" hangingPunct="1">
        <a:defRPr sz="3690" kern="1200">
          <a:solidFill>
            <a:schemeClr val="tx1"/>
          </a:solidFill>
          <a:latin typeface="+mn-lt"/>
          <a:ea typeface="+mn-ea"/>
          <a:cs typeface="+mn-cs"/>
        </a:defRPr>
      </a:lvl4pPr>
      <a:lvl5pPr marL="3748674" algn="l" defTabSz="1874337" rtl="0" eaLnBrk="1" latinLnBrk="0" hangingPunct="1">
        <a:defRPr sz="3690" kern="1200">
          <a:solidFill>
            <a:schemeClr val="tx1"/>
          </a:solidFill>
          <a:latin typeface="+mn-lt"/>
          <a:ea typeface="+mn-ea"/>
          <a:cs typeface="+mn-cs"/>
        </a:defRPr>
      </a:lvl5pPr>
      <a:lvl6pPr marL="4685843" algn="l" defTabSz="1874337" rtl="0" eaLnBrk="1" latinLnBrk="0" hangingPunct="1">
        <a:defRPr sz="3690" kern="1200">
          <a:solidFill>
            <a:schemeClr val="tx1"/>
          </a:solidFill>
          <a:latin typeface="+mn-lt"/>
          <a:ea typeface="+mn-ea"/>
          <a:cs typeface="+mn-cs"/>
        </a:defRPr>
      </a:lvl6pPr>
      <a:lvl7pPr marL="5623011" algn="l" defTabSz="1874337" rtl="0" eaLnBrk="1" latinLnBrk="0" hangingPunct="1">
        <a:defRPr sz="3690" kern="1200">
          <a:solidFill>
            <a:schemeClr val="tx1"/>
          </a:solidFill>
          <a:latin typeface="+mn-lt"/>
          <a:ea typeface="+mn-ea"/>
          <a:cs typeface="+mn-cs"/>
        </a:defRPr>
      </a:lvl7pPr>
      <a:lvl8pPr marL="6560180" algn="l" defTabSz="1874337" rtl="0" eaLnBrk="1" latinLnBrk="0" hangingPunct="1">
        <a:defRPr sz="3690" kern="1200">
          <a:solidFill>
            <a:schemeClr val="tx1"/>
          </a:solidFill>
          <a:latin typeface="+mn-lt"/>
          <a:ea typeface="+mn-ea"/>
          <a:cs typeface="+mn-cs"/>
        </a:defRPr>
      </a:lvl8pPr>
      <a:lvl9pPr marL="7497348" algn="l" defTabSz="1874337" rtl="0" eaLnBrk="1" latinLnBrk="0" hangingPunct="1">
        <a:defRPr sz="36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17" Type="http://schemas.openxmlformats.org/officeDocument/2006/relationships/chart" Target="../charts/chart16.xml"/><Relationship Id="rId2" Type="http://schemas.openxmlformats.org/officeDocument/2006/relationships/chart" Target="../charts/chart1.xml"/><Relationship Id="rId16" Type="http://schemas.openxmlformats.org/officeDocument/2006/relationships/chart" Target="../charts/chart15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" name="Graphique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89930017"/>
              </p:ext>
            </p:extLst>
          </p:nvPr>
        </p:nvGraphicFramePr>
        <p:xfrm>
          <a:off x="9579772" y="3270191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0" name="Graphique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4761043"/>
              </p:ext>
            </p:extLst>
          </p:nvPr>
        </p:nvGraphicFramePr>
        <p:xfrm>
          <a:off x="14295195" y="3270191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1" name="Graphique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84736341"/>
              </p:ext>
            </p:extLst>
          </p:nvPr>
        </p:nvGraphicFramePr>
        <p:xfrm>
          <a:off x="4901900" y="1013629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2" name="Graphique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28561525"/>
              </p:ext>
            </p:extLst>
          </p:nvPr>
        </p:nvGraphicFramePr>
        <p:xfrm>
          <a:off x="9579772" y="1013629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3" name="Graphique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92738808"/>
              </p:ext>
            </p:extLst>
          </p:nvPr>
        </p:nvGraphicFramePr>
        <p:xfrm>
          <a:off x="14295195" y="1013629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4" name="Graphique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39688767"/>
              </p:ext>
            </p:extLst>
          </p:nvPr>
        </p:nvGraphicFramePr>
        <p:xfrm>
          <a:off x="14295195" y="669731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5" name="Graphique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8188264"/>
              </p:ext>
            </p:extLst>
          </p:nvPr>
        </p:nvGraphicFramePr>
        <p:xfrm>
          <a:off x="170717" y="1013629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6" name="Graphique 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69300535"/>
              </p:ext>
            </p:extLst>
          </p:nvPr>
        </p:nvGraphicFramePr>
        <p:xfrm>
          <a:off x="9579772" y="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27" name="Graphique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19164087"/>
              </p:ext>
            </p:extLst>
          </p:nvPr>
        </p:nvGraphicFramePr>
        <p:xfrm>
          <a:off x="4901900" y="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28" name="Graphique 2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53476914"/>
              </p:ext>
            </p:extLst>
          </p:nvPr>
        </p:nvGraphicFramePr>
        <p:xfrm>
          <a:off x="14295195" y="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29" name="Graphique 2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14131187"/>
              </p:ext>
            </p:extLst>
          </p:nvPr>
        </p:nvGraphicFramePr>
        <p:xfrm>
          <a:off x="170717" y="3270191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30" name="Graphique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34322683"/>
              </p:ext>
            </p:extLst>
          </p:nvPr>
        </p:nvGraphicFramePr>
        <p:xfrm>
          <a:off x="4901900" y="3270191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31" name="Graphique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10267267"/>
              </p:ext>
            </p:extLst>
          </p:nvPr>
        </p:nvGraphicFramePr>
        <p:xfrm>
          <a:off x="9579772" y="669731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32" name="Graphique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71892027"/>
              </p:ext>
            </p:extLst>
          </p:nvPr>
        </p:nvGraphicFramePr>
        <p:xfrm>
          <a:off x="170717" y="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33" name="Graphique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9564684"/>
              </p:ext>
            </p:extLst>
          </p:nvPr>
        </p:nvGraphicFramePr>
        <p:xfrm>
          <a:off x="170717" y="669731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34" name="Graphique 3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567384"/>
              </p:ext>
            </p:extLst>
          </p:nvPr>
        </p:nvGraphicFramePr>
        <p:xfrm>
          <a:off x="4901900" y="669731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sp>
        <p:nvSpPr>
          <p:cNvPr id="2" name="ZoneTexte 1">
            <a:extLst>
              <a:ext uri="{FF2B5EF4-FFF2-40B4-BE49-F238E27FC236}">
                <a16:creationId xmlns:a16="http://schemas.microsoft.com/office/drawing/2014/main" id="{F4BE4C62-608C-4F3A-AE81-CF607D031B18}"/>
              </a:ext>
            </a:extLst>
          </p:cNvPr>
          <p:cNvSpPr txBox="1"/>
          <p:nvPr/>
        </p:nvSpPr>
        <p:spPr>
          <a:xfrm>
            <a:off x="348733" y="2847293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66DC2276-513C-4D6A-BAD5-96D544B48DBA}"/>
              </a:ext>
            </a:extLst>
          </p:cNvPr>
          <p:cNvSpPr txBox="1"/>
          <p:nvPr/>
        </p:nvSpPr>
        <p:spPr>
          <a:xfrm>
            <a:off x="2339565" y="2847293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4" name="Connecteur droit 3">
            <a:extLst>
              <a:ext uri="{FF2B5EF4-FFF2-40B4-BE49-F238E27FC236}">
                <a16:creationId xmlns:a16="http://schemas.microsoft.com/office/drawing/2014/main" id="{4C749DA5-646F-4B64-8CEA-BDFE9180322C}"/>
              </a:ext>
            </a:extLst>
          </p:cNvPr>
          <p:cNvCxnSpPr>
            <a:cxnSpLocks/>
          </p:cNvCxnSpPr>
          <p:nvPr/>
        </p:nvCxnSpPr>
        <p:spPr>
          <a:xfrm>
            <a:off x="1126218" y="2783788"/>
            <a:ext cx="33643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Connecteur droit 4">
            <a:extLst>
              <a:ext uri="{FF2B5EF4-FFF2-40B4-BE49-F238E27FC236}">
                <a16:creationId xmlns:a16="http://schemas.microsoft.com/office/drawing/2014/main" id="{8957A334-17C9-45D9-9F13-C0B4D1D395E2}"/>
              </a:ext>
            </a:extLst>
          </p:cNvPr>
          <p:cNvCxnSpPr>
            <a:cxnSpLocks/>
          </p:cNvCxnSpPr>
          <p:nvPr/>
        </p:nvCxnSpPr>
        <p:spPr>
          <a:xfrm>
            <a:off x="628239" y="2783788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ZoneTexte 5">
            <a:extLst>
              <a:ext uri="{FF2B5EF4-FFF2-40B4-BE49-F238E27FC236}">
                <a16:creationId xmlns:a16="http://schemas.microsoft.com/office/drawing/2014/main" id="{25A269C1-B915-4B15-8CB1-B37DDAEAB374}"/>
              </a:ext>
            </a:extLst>
          </p:cNvPr>
          <p:cNvSpPr txBox="1"/>
          <p:nvPr/>
        </p:nvSpPr>
        <p:spPr>
          <a:xfrm>
            <a:off x="5201469" y="2847293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6348F773-35A2-4E10-9A86-52788EE48AA9}"/>
              </a:ext>
            </a:extLst>
          </p:cNvPr>
          <p:cNvSpPr txBox="1"/>
          <p:nvPr/>
        </p:nvSpPr>
        <p:spPr>
          <a:xfrm>
            <a:off x="7160217" y="2847293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8" name="Connecteur droit 7">
            <a:extLst>
              <a:ext uri="{FF2B5EF4-FFF2-40B4-BE49-F238E27FC236}">
                <a16:creationId xmlns:a16="http://schemas.microsoft.com/office/drawing/2014/main" id="{A4B4C1D3-C381-4AB4-AC93-853C0F4BD6D8}"/>
              </a:ext>
            </a:extLst>
          </p:cNvPr>
          <p:cNvCxnSpPr>
            <a:cxnSpLocks/>
          </p:cNvCxnSpPr>
          <p:nvPr/>
        </p:nvCxnSpPr>
        <p:spPr>
          <a:xfrm>
            <a:off x="5914786" y="2783788"/>
            <a:ext cx="33643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Connecteur droit 8">
            <a:extLst>
              <a:ext uri="{FF2B5EF4-FFF2-40B4-BE49-F238E27FC236}">
                <a16:creationId xmlns:a16="http://schemas.microsoft.com/office/drawing/2014/main" id="{86F21469-2FBF-41C4-B1A4-3B82A4098A6A}"/>
              </a:ext>
            </a:extLst>
          </p:cNvPr>
          <p:cNvCxnSpPr>
            <a:cxnSpLocks/>
          </p:cNvCxnSpPr>
          <p:nvPr/>
        </p:nvCxnSpPr>
        <p:spPr>
          <a:xfrm>
            <a:off x="5480975" y="2783788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ZoneTexte 9">
            <a:extLst>
              <a:ext uri="{FF2B5EF4-FFF2-40B4-BE49-F238E27FC236}">
                <a16:creationId xmlns:a16="http://schemas.microsoft.com/office/drawing/2014/main" id="{722FF530-7C35-4127-96D2-51610B933F30}"/>
              </a:ext>
            </a:extLst>
          </p:cNvPr>
          <p:cNvSpPr txBox="1"/>
          <p:nvPr/>
        </p:nvSpPr>
        <p:spPr>
          <a:xfrm>
            <a:off x="9869723" y="2845042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7D40B932-F004-40A3-B74B-28D39AC4B202}"/>
              </a:ext>
            </a:extLst>
          </p:cNvPr>
          <p:cNvSpPr txBox="1"/>
          <p:nvPr/>
        </p:nvSpPr>
        <p:spPr>
          <a:xfrm>
            <a:off x="11812429" y="2845042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12" name="Connecteur droit 11">
            <a:extLst>
              <a:ext uri="{FF2B5EF4-FFF2-40B4-BE49-F238E27FC236}">
                <a16:creationId xmlns:a16="http://schemas.microsoft.com/office/drawing/2014/main" id="{138B5717-80C6-4DBD-83F1-997FE5A4BD9E}"/>
              </a:ext>
            </a:extLst>
          </p:cNvPr>
          <p:cNvCxnSpPr>
            <a:cxnSpLocks/>
          </p:cNvCxnSpPr>
          <p:nvPr/>
        </p:nvCxnSpPr>
        <p:spPr>
          <a:xfrm>
            <a:off x="10599082" y="2781537"/>
            <a:ext cx="33643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Connecteur droit 12">
            <a:extLst>
              <a:ext uri="{FF2B5EF4-FFF2-40B4-BE49-F238E27FC236}">
                <a16:creationId xmlns:a16="http://schemas.microsoft.com/office/drawing/2014/main" id="{052E276E-1E49-4F6F-B37A-312531F128BF}"/>
              </a:ext>
            </a:extLst>
          </p:cNvPr>
          <p:cNvCxnSpPr>
            <a:cxnSpLocks/>
          </p:cNvCxnSpPr>
          <p:nvPr/>
        </p:nvCxnSpPr>
        <p:spPr>
          <a:xfrm>
            <a:off x="10149229" y="2781537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ZoneTexte 13">
            <a:extLst>
              <a:ext uri="{FF2B5EF4-FFF2-40B4-BE49-F238E27FC236}">
                <a16:creationId xmlns:a16="http://schemas.microsoft.com/office/drawing/2014/main" id="{F51A1AED-8648-4C56-A5AB-FC05F7C269DE}"/>
              </a:ext>
            </a:extLst>
          </p:cNvPr>
          <p:cNvSpPr txBox="1"/>
          <p:nvPr/>
        </p:nvSpPr>
        <p:spPr>
          <a:xfrm>
            <a:off x="14537977" y="2842791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71D23944-42C0-4E54-BE06-1C7842FC90DF}"/>
              </a:ext>
            </a:extLst>
          </p:cNvPr>
          <p:cNvSpPr txBox="1"/>
          <p:nvPr/>
        </p:nvSpPr>
        <p:spPr>
          <a:xfrm>
            <a:off x="16512767" y="2842791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16" name="Connecteur droit 15">
            <a:extLst>
              <a:ext uri="{FF2B5EF4-FFF2-40B4-BE49-F238E27FC236}">
                <a16:creationId xmlns:a16="http://schemas.microsoft.com/office/drawing/2014/main" id="{16F1C9FA-201E-4740-AB62-616AF46835BD}"/>
              </a:ext>
            </a:extLst>
          </p:cNvPr>
          <p:cNvCxnSpPr>
            <a:cxnSpLocks/>
          </p:cNvCxnSpPr>
          <p:nvPr/>
        </p:nvCxnSpPr>
        <p:spPr>
          <a:xfrm>
            <a:off x="15299420" y="2779286"/>
            <a:ext cx="33643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Connecteur droit 16">
            <a:extLst>
              <a:ext uri="{FF2B5EF4-FFF2-40B4-BE49-F238E27FC236}">
                <a16:creationId xmlns:a16="http://schemas.microsoft.com/office/drawing/2014/main" id="{6A7599AB-ED60-4BF6-B99C-9FDE7CF6CB61}"/>
              </a:ext>
            </a:extLst>
          </p:cNvPr>
          <p:cNvCxnSpPr>
            <a:cxnSpLocks/>
          </p:cNvCxnSpPr>
          <p:nvPr/>
        </p:nvCxnSpPr>
        <p:spPr>
          <a:xfrm>
            <a:off x="14817483" y="2779286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ZoneTexte 51">
            <a:extLst>
              <a:ext uri="{FF2B5EF4-FFF2-40B4-BE49-F238E27FC236}">
                <a16:creationId xmlns:a16="http://schemas.microsoft.com/office/drawing/2014/main" id="{8CAD797A-D2CD-4814-9D53-5A9B30A85886}"/>
              </a:ext>
            </a:extLst>
          </p:cNvPr>
          <p:cNvSpPr txBox="1"/>
          <p:nvPr/>
        </p:nvSpPr>
        <p:spPr>
          <a:xfrm>
            <a:off x="351754" y="6151822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54" name="ZoneTexte 53">
            <a:extLst>
              <a:ext uri="{FF2B5EF4-FFF2-40B4-BE49-F238E27FC236}">
                <a16:creationId xmlns:a16="http://schemas.microsoft.com/office/drawing/2014/main" id="{CB4083AD-0083-45F9-9E18-9813530C25C0}"/>
              </a:ext>
            </a:extLst>
          </p:cNvPr>
          <p:cNvSpPr txBox="1"/>
          <p:nvPr/>
        </p:nvSpPr>
        <p:spPr>
          <a:xfrm>
            <a:off x="2342586" y="6151822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56" name="Connecteur droit 55">
            <a:extLst>
              <a:ext uri="{FF2B5EF4-FFF2-40B4-BE49-F238E27FC236}">
                <a16:creationId xmlns:a16="http://schemas.microsoft.com/office/drawing/2014/main" id="{FEABA6C5-C25C-4288-9888-C74F12502084}"/>
              </a:ext>
            </a:extLst>
          </p:cNvPr>
          <p:cNvCxnSpPr>
            <a:cxnSpLocks/>
          </p:cNvCxnSpPr>
          <p:nvPr/>
        </p:nvCxnSpPr>
        <p:spPr>
          <a:xfrm>
            <a:off x="1129239" y="6088317"/>
            <a:ext cx="33643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Connecteur droit 57">
            <a:extLst>
              <a:ext uri="{FF2B5EF4-FFF2-40B4-BE49-F238E27FC236}">
                <a16:creationId xmlns:a16="http://schemas.microsoft.com/office/drawing/2014/main" id="{58FC4851-9728-466B-960D-CFD767B1E695}"/>
              </a:ext>
            </a:extLst>
          </p:cNvPr>
          <p:cNvCxnSpPr>
            <a:cxnSpLocks/>
          </p:cNvCxnSpPr>
          <p:nvPr/>
        </p:nvCxnSpPr>
        <p:spPr>
          <a:xfrm>
            <a:off x="631260" y="6088317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ZoneTexte 59">
            <a:extLst>
              <a:ext uri="{FF2B5EF4-FFF2-40B4-BE49-F238E27FC236}">
                <a16:creationId xmlns:a16="http://schemas.microsoft.com/office/drawing/2014/main" id="{0CD9AAF0-18F5-4F07-8D19-6A3C43AF5ABC}"/>
              </a:ext>
            </a:extLst>
          </p:cNvPr>
          <p:cNvSpPr txBox="1"/>
          <p:nvPr/>
        </p:nvSpPr>
        <p:spPr>
          <a:xfrm>
            <a:off x="5137301" y="6151822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62" name="ZoneTexte 61">
            <a:extLst>
              <a:ext uri="{FF2B5EF4-FFF2-40B4-BE49-F238E27FC236}">
                <a16:creationId xmlns:a16="http://schemas.microsoft.com/office/drawing/2014/main" id="{53936251-F52B-40D3-9141-72CBA6BE83E5}"/>
              </a:ext>
            </a:extLst>
          </p:cNvPr>
          <p:cNvSpPr txBox="1"/>
          <p:nvPr/>
        </p:nvSpPr>
        <p:spPr>
          <a:xfrm>
            <a:off x="7128133" y="6151822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64" name="Connecteur droit 63">
            <a:extLst>
              <a:ext uri="{FF2B5EF4-FFF2-40B4-BE49-F238E27FC236}">
                <a16:creationId xmlns:a16="http://schemas.microsoft.com/office/drawing/2014/main" id="{61FB8303-681E-4865-A637-5B95EEE9CFD4}"/>
              </a:ext>
            </a:extLst>
          </p:cNvPr>
          <p:cNvCxnSpPr>
            <a:cxnSpLocks/>
          </p:cNvCxnSpPr>
          <p:nvPr/>
        </p:nvCxnSpPr>
        <p:spPr>
          <a:xfrm>
            <a:off x="5914786" y="6088317"/>
            <a:ext cx="33643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Connecteur droit 65">
            <a:extLst>
              <a:ext uri="{FF2B5EF4-FFF2-40B4-BE49-F238E27FC236}">
                <a16:creationId xmlns:a16="http://schemas.microsoft.com/office/drawing/2014/main" id="{728B9958-A111-4386-961C-DCE250400361}"/>
              </a:ext>
            </a:extLst>
          </p:cNvPr>
          <p:cNvCxnSpPr>
            <a:cxnSpLocks/>
          </p:cNvCxnSpPr>
          <p:nvPr/>
        </p:nvCxnSpPr>
        <p:spPr>
          <a:xfrm>
            <a:off x="5416807" y="6088317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ZoneTexte 67">
            <a:extLst>
              <a:ext uri="{FF2B5EF4-FFF2-40B4-BE49-F238E27FC236}">
                <a16:creationId xmlns:a16="http://schemas.microsoft.com/office/drawing/2014/main" id="{1B2F959B-23F3-4AB3-844A-4C501BA3EC89}"/>
              </a:ext>
            </a:extLst>
          </p:cNvPr>
          <p:cNvSpPr txBox="1"/>
          <p:nvPr/>
        </p:nvSpPr>
        <p:spPr>
          <a:xfrm>
            <a:off x="14536999" y="6148400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70" name="ZoneTexte 69">
            <a:extLst>
              <a:ext uri="{FF2B5EF4-FFF2-40B4-BE49-F238E27FC236}">
                <a16:creationId xmlns:a16="http://schemas.microsoft.com/office/drawing/2014/main" id="{5576CF83-9350-4CD9-BECB-BB618282001C}"/>
              </a:ext>
            </a:extLst>
          </p:cNvPr>
          <p:cNvSpPr txBox="1"/>
          <p:nvPr/>
        </p:nvSpPr>
        <p:spPr>
          <a:xfrm>
            <a:off x="16527831" y="6148400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72" name="Connecteur droit 71">
            <a:extLst>
              <a:ext uri="{FF2B5EF4-FFF2-40B4-BE49-F238E27FC236}">
                <a16:creationId xmlns:a16="http://schemas.microsoft.com/office/drawing/2014/main" id="{1536F71C-85F3-4A0B-BAD4-355A6E0CD564}"/>
              </a:ext>
            </a:extLst>
          </p:cNvPr>
          <p:cNvCxnSpPr>
            <a:cxnSpLocks/>
          </p:cNvCxnSpPr>
          <p:nvPr/>
        </p:nvCxnSpPr>
        <p:spPr>
          <a:xfrm>
            <a:off x="15314484" y="6084895"/>
            <a:ext cx="33643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Connecteur droit 73">
            <a:extLst>
              <a:ext uri="{FF2B5EF4-FFF2-40B4-BE49-F238E27FC236}">
                <a16:creationId xmlns:a16="http://schemas.microsoft.com/office/drawing/2014/main" id="{A22AF475-D964-46DC-A8BF-0A999F5564F5}"/>
              </a:ext>
            </a:extLst>
          </p:cNvPr>
          <p:cNvCxnSpPr>
            <a:cxnSpLocks/>
          </p:cNvCxnSpPr>
          <p:nvPr/>
        </p:nvCxnSpPr>
        <p:spPr>
          <a:xfrm>
            <a:off x="14816505" y="6084895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6" name="ZoneTexte 75">
            <a:extLst>
              <a:ext uri="{FF2B5EF4-FFF2-40B4-BE49-F238E27FC236}">
                <a16:creationId xmlns:a16="http://schemas.microsoft.com/office/drawing/2014/main" id="{FCCB7B4E-0F21-4C69-9AF3-1A16FF65B022}"/>
              </a:ext>
            </a:extLst>
          </p:cNvPr>
          <p:cNvSpPr txBox="1"/>
          <p:nvPr/>
        </p:nvSpPr>
        <p:spPr>
          <a:xfrm>
            <a:off x="348733" y="9581781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78" name="ZoneTexte 77">
            <a:extLst>
              <a:ext uri="{FF2B5EF4-FFF2-40B4-BE49-F238E27FC236}">
                <a16:creationId xmlns:a16="http://schemas.microsoft.com/office/drawing/2014/main" id="{EF118B94-9B79-44FC-BEA1-14C521B83158}"/>
              </a:ext>
            </a:extLst>
          </p:cNvPr>
          <p:cNvSpPr txBox="1"/>
          <p:nvPr/>
        </p:nvSpPr>
        <p:spPr>
          <a:xfrm>
            <a:off x="2339565" y="9581781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80" name="Connecteur droit 79">
            <a:extLst>
              <a:ext uri="{FF2B5EF4-FFF2-40B4-BE49-F238E27FC236}">
                <a16:creationId xmlns:a16="http://schemas.microsoft.com/office/drawing/2014/main" id="{593DB45E-0421-448D-900D-AF996A66C627}"/>
              </a:ext>
            </a:extLst>
          </p:cNvPr>
          <p:cNvCxnSpPr>
            <a:cxnSpLocks/>
          </p:cNvCxnSpPr>
          <p:nvPr/>
        </p:nvCxnSpPr>
        <p:spPr>
          <a:xfrm>
            <a:off x="1126218" y="9518276"/>
            <a:ext cx="33643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Connecteur droit 81">
            <a:extLst>
              <a:ext uri="{FF2B5EF4-FFF2-40B4-BE49-F238E27FC236}">
                <a16:creationId xmlns:a16="http://schemas.microsoft.com/office/drawing/2014/main" id="{53172364-068C-4F5B-B220-283CD03E0666}"/>
              </a:ext>
            </a:extLst>
          </p:cNvPr>
          <p:cNvCxnSpPr>
            <a:cxnSpLocks/>
          </p:cNvCxnSpPr>
          <p:nvPr/>
        </p:nvCxnSpPr>
        <p:spPr>
          <a:xfrm>
            <a:off x="628239" y="9518276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ZoneTexte 83">
            <a:extLst>
              <a:ext uri="{FF2B5EF4-FFF2-40B4-BE49-F238E27FC236}">
                <a16:creationId xmlns:a16="http://schemas.microsoft.com/office/drawing/2014/main" id="{E980903B-EB9A-43DD-9E92-D6936FE02222}"/>
              </a:ext>
            </a:extLst>
          </p:cNvPr>
          <p:cNvSpPr txBox="1"/>
          <p:nvPr/>
        </p:nvSpPr>
        <p:spPr>
          <a:xfrm>
            <a:off x="5089175" y="13047243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86" name="ZoneTexte 85">
            <a:extLst>
              <a:ext uri="{FF2B5EF4-FFF2-40B4-BE49-F238E27FC236}">
                <a16:creationId xmlns:a16="http://schemas.microsoft.com/office/drawing/2014/main" id="{0789B833-23B4-4122-8E51-06EE4B5DC0A9}"/>
              </a:ext>
            </a:extLst>
          </p:cNvPr>
          <p:cNvSpPr txBox="1"/>
          <p:nvPr/>
        </p:nvSpPr>
        <p:spPr>
          <a:xfrm>
            <a:off x="7080007" y="13047243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88" name="Connecteur droit 87">
            <a:extLst>
              <a:ext uri="{FF2B5EF4-FFF2-40B4-BE49-F238E27FC236}">
                <a16:creationId xmlns:a16="http://schemas.microsoft.com/office/drawing/2014/main" id="{6E88D4B9-35BD-4C73-9DF0-36E16504A2F3}"/>
              </a:ext>
            </a:extLst>
          </p:cNvPr>
          <p:cNvCxnSpPr>
            <a:cxnSpLocks/>
          </p:cNvCxnSpPr>
          <p:nvPr/>
        </p:nvCxnSpPr>
        <p:spPr>
          <a:xfrm>
            <a:off x="5866660" y="12983738"/>
            <a:ext cx="33643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Connecteur droit 89">
            <a:extLst>
              <a:ext uri="{FF2B5EF4-FFF2-40B4-BE49-F238E27FC236}">
                <a16:creationId xmlns:a16="http://schemas.microsoft.com/office/drawing/2014/main" id="{7BE24183-D02E-4945-92C2-07F5211AEFAF}"/>
              </a:ext>
            </a:extLst>
          </p:cNvPr>
          <p:cNvCxnSpPr>
            <a:cxnSpLocks/>
          </p:cNvCxnSpPr>
          <p:nvPr/>
        </p:nvCxnSpPr>
        <p:spPr>
          <a:xfrm>
            <a:off x="5368681" y="12983738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ZoneTexte 91">
            <a:extLst>
              <a:ext uri="{FF2B5EF4-FFF2-40B4-BE49-F238E27FC236}">
                <a16:creationId xmlns:a16="http://schemas.microsoft.com/office/drawing/2014/main" id="{296A0B1B-65CD-42A2-93FA-778CFF8EEA96}"/>
              </a:ext>
            </a:extLst>
          </p:cNvPr>
          <p:cNvSpPr txBox="1"/>
          <p:nvPr/>
        </p:nvSpPr>
        <p:spPr>
          <a:xfrm>
            <a:off x="9805555" y="13047243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94" name="ZoneTexte 93">
            <a:extLst>
              <a:ext uri="{FF2B5EF4-FFF2-40B4-BE49-F238E27FC236}">
                <a16:creationId xmlns:a16="http://schemas.microsoft.com/office/drawing/2014/main" id="{F2812FCC-A452-4B94-B095-CBC7A1F24F07}"/>
              </a:ext>
            </a:extLst>
          </p:cNvPr>
          <p:cNvSpPr txBox="1"/>
          <p:nvPr/>
        </p:nvSpPr>
        <p:spPr>
          <a:xfrm>
            <a:off x="11796387" y="13047243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96" name="Connecteur droit 95">
            <a:extLst>
              <a:ext uri="{FF2B5EF4-FFF2-40B4-BE49-F238E27FC236}">
                <a16:creationId xmlns:a16="http://schemas.microsoft.com/office/drawing/2014/main" id="{85076F39-58F8-417A-9E2C-7AEAD7FC69EA}"/>
              </a:ext>
            </a:extLst>
          </p:cNvPr>
          <p:cNvCxnSpPr>
            <a:cxnSpLocks/>
          </p:cNvCxnSpPr>
          <p:nvPr/>
        </p:nvCxnSpPr>
        <p:spPr>
          <a:xfrm>
            <a:off x="10583040" y="12983738"/>
            <a:ext cx="33643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8" name="Connecteur droit 97">
            <a:extLst>
              <a:ext uri="{FF2B5EF4-FFF2-40B4-BE49-F238E27FC236}">
                <a16:creationId xmlns:a16="http://schemas.microsoft.com/office/drawing/2014/main" id="{240CB70D-7AF2-4F3A-A5A9-F128FCCED0FF}"/>
              </a:ext>
            </a:extLst>
          </p:cNvPr>
          <p:cNvCxnSpPr>
            <a:cxnSpLocks/>
          </p:cNvCxnSpPr>
          <p:nvPr/>
        </p:nvCxnSpPr>
        <p:spPr>
          <a:xfrm>
            <a:off x="10085061" y="12983738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0" name="ZoneTexte 99">
            <a:extLst>
              <a:ext uri="{FF2B5EF4-FFF2-40B4-BE49-F238E27FC236}">
                <a16:creationId xmlns:a16="http://schemas.microsoft.com/office/drawing/2014/main" id="{D89DC604-B8C3-4B60-AF6A-02702E7EACA9}"/>
              </a:ext>
            </a:extLst>
          </p:cNvPr>
          <p:cNvSpPr txBox="1"/>
          <p:nvPr/>
        </p:nvSpPr>
        <p:spPr>
          <a:xfrm>
            <a:off x="14472831" y="13047243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102" name="ZoneTexte 101">
            <a:extLst>
              <a:ext uri="{FF2B5EF4-FFF2-40B4-BE49-F238E27FC236}">
                <a16:creationId xmlns:a16="http://schemas.microsoft.com/office/drawing/2014/main" id="{D5220125-9D4A-403D-858E-823986B7DDE4}"/>
              </a:ext>
            </a:extLst>
          </p:cNvPr>
          <p:cNvSpPr txBox="1"/>
          <p:nvPr/>
        </p:nvSpPr>
        <p:spPr>
          <a:xfrm>
            <a:off x="16463663" y="13047243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104" name="Connecteur droit 103">
            <a:extLst>
              <a:ext uri="{FF2B5EF4-FFF2-40B4-BE49-F238E27FC236}">
                <a16:creationId xmlns:a16="http://schemas.microsoft.com/office/drawing/2014/main" id="{E0576602-783C-419B-9F2A-A4C743E30FAC}"/>
              </a:ext>
            </a:extLst>
          </p:cNvPr>
          <p:cNvCxnSpPr>
            <a:cxnSpLocks/>
          </p:cNvCxnSpPr>
          <p:nvPr/>
        </p:nvCxnSpPr>
        <p:spPr>
          <a:xfrm>
            <a:off x="15250316" y="12983738"/>
            <a:ext cx="33643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6" name="Connecteur droit 105">
            <a:extLst>
              <a:ext uri="{FF2B5EF4-FFF2-40B4-BE49-F238E27FC236}">
                <a16:creationId xmlns:a16="http://schemas.microsoft.com/office/drawing/2014/main" id="{4E8B699B-5CCA-439E-9CB0-EDF1B6B804F8}"/>
              </a:ext>
            </a:extLst>
          </p:cNvPr>
          <p:cNvCxnSpPr>
            <a:cxnSpLocks/>
          </p:cNvCxnSpPr>
          <p:nvPr/>
        </p:nvCxnSpPr>
        <p:spPr>
          <a:xfrm>
            <a:off x="14752337" y="12983738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8" name="ZoneTexte 107">
            <a:extLst>
              <a:ext uri="{FF2B5EF4-FFF2-40B4-BE49-F238E27FC236}">
                <a16:creationId xmlns:a16="http://schemas.microsoft.com/office/drawing/2014/main" id="{4D206894-4848-4216-BACF-6ECE8669D3CD}"/>
              </a:ext>
            </a:extLst>
          </p:cNvPr>
          <p:cNvSpPr txBox="1"/>
          <p:nvPr/>
        </p:nvSpPr>
        <p:spPr>
          <a:xfrm>
            <a:off x="9822837" y="6148400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110" name="ZoneTexte 109">
            <a:extLst>
              <a:ext uri="{FF2B5EF4-FFF2-40B4-BE49-F238E27FC236}">
                <a16:creationId xmlns:a16="http://schemas.microsoft.com/office/drawing/2014/main" id="{5D69798A-3CEE-4EC2-A9B1-9EC69709F12B}"/>
              </a:ext>
            </a:extLst>
          </p:cNvPr>
          <p:cNvSpPr txBox="1"/>
          <p:nvPr/>
        </p:nvSpPr>
        <p:spPr>
          <a:xfrm>
            <a:off x="11765543" y="6148400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112" name="Connecteur droit 111">
            <a:extLst>
              <a:ext uri="{FF2B5EF4-FFF2-40B4-BE49-F238E27FC236}">
                <a16:creationId xmlns:a16="http://schemas.microsoft.com/office/drawing/2014/main" id="{78545424-B925-4FB0-BC3A-72CD9DC3E135}"/>
              </a:ext>
            </a:extLst>
          </p:cNvPr>
          <p:cNvCxnSpPr>
            <a:cxnSpLocks/>
          </p:cNvCxnSpPr>
          <p:nvPr/>
        </p:nvCxnSpPr>
        <p:spPr>
          <a:xfrm>
            <a:off x="10552196" y="6084895"/>
            <a:ext cx="33643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4" name="Connecteur droit 113">
            <a:extLst>
              <a:ext uri="{FF2B5EF4-FFF2-40B4-BE49-F238E27FC236}">
                <a16:creationId xmlns:a16="http://schemas.microsoft.com/office/drawing/2014/main" id="{5919857B-2315-4A23-AAA4-B42EFFA5A08F}"/>
              </a:ext>
            </a:extLst>
          </p:cNvPr>
          <p:cNvCxnSpPr>
            <a:cxnSpLocks/>
          </p:cNvCxnSpPr>
          <p:nvPr/>
        </p:nvCxnSpPr>
        <p:spPr>
          <a:xfrm>
            <a:off x="10102343" y="6084895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6" name="ZoneTexte 115">
            <a:extLst>
              <a:ext uri="{FF2B5EF4-FFF2-40B4-BE49-F238E27FC236}">
                <a16:creationId xmlns:a16="http://schemas.microsoft.com/office/drawing/2014/main" id="{DFE078FC-B191-460D-AD42-CB956E444479}"/>
              </a:ext>
            </a:extLst>
          </p:cNvPr>
          <p:cNvSpPr txBox="1"/>
          <p:nvPr/>
        </p:nvSpPr>
        <p:spPr>
          <a:xfrm>
            <a:off x="5145758" y="9572781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118" name="ZoneTexte 117">
            <a:extLst>
              <a:ext uri="{FF2B5EF4-FFF2-40B4-BE49-F238E27FC236}">
                <a16:creationId xmlns:a16="http://schemas.microsoft.com/office/drawing/2014/main" id="{C54031EC-76A4-4D6E-81DE-66A9F4F90EC9}"/>
              </a:ext>
            </a:extLst>
          </p:cNvPr>
          <p:cNvSpPr txBox="1"/>
          <p:nvPr/>
        </p:nvSpPr>
        <p:spPr>
          <a:xfrm>
            <a:off x="7088464" y="9572781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120" name="Connecteur droit 119">
            <a:extLst>
              <a:ext uri="{FF2B5EF4-FFF2-40B4-BE49-F238E27FC236}">
                <a16:creationId xmlns:a16="http://schemas.microsoft.com/office/drawing/2014/main" id="{2690000B-9302-46FE-A4FF-AB24A06A5460}"/>
              </a:ext>
            </a:extLst>
          </p:cNvPr>
          <p:cNvCxnSpPr>
            <a:cxnSpLocks/>
          </p:cNvCxnSpPr>
          <p:nvPr/>
        </p:nvCxnSpPr>
        <p:spPr>
          <a:xfrm>
            <a:off x="5875117" y="9509276"/>
            <a:ext cx="33643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2" name="Connecteur droit 121">
            <a:extLst>
              <a:ext uri="{FF2B5EF4-FFF2-40B4-BE49-F238E27FC236}">
                <a16:creationId xmlns:a16="http://schemas.microsoft.com/office/drawing/2014/main" id="{14DC7318-905F-4A1A-BB6F-8FEDC7267355}"/>
              </a:ext>
            </a:extLst>
          </p:cNvPr>
          <p:cNvCxnSpPr>
            <a:cxnSpLocks/>
          </p:cNvCxnSpPr>
          <p:nvPr/>
        </p:nvCxnSpPr>
        <p:spPr>
          <a:xfrm>
            <a:off x="5425264" y="9509276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4" name="ZoneTexte 123">
            <a:extLst>
              <a:ext uri="{FF2B5EF4-FFF2-40B4-BE49-F238E27FC236}">
                <a16:creationId xmlns:a16="http://schemas.microsoft.com/office/drawing/2014/main" id="{347038A3-883B-4A66-B8F2-DA9FF37A69E2}"/>
              </a:ext>
            </a:extLst>
          </p:cNvPr>
          <p:cNvSpPr txBox="1"/>
          <p:nvPr/>
        </p:nvSpPr>
        <p:spPr>
          <a:xfrm>
            <a:off x="9837639" y="9581781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126" name="ZoneTexte 125">
            <a:extLst>
              <a:ext uri="{FF2B5EF4-FFF2-40B4-BE49-F238E27FC236}">
                <a16:creationId xmlns:a16="http://schemas.microsoft.com/office/drawing/2014/main" id="{1149546F-7D0F-44AE-A0A0-486B639E9FF8}"/>
              </a:ext>
            </a:extLst>
          </p:cNvPr>
          <p:cNvSpPr txBox="1"/>
          <p:nvPr/>
        </p:nvSpPr>
        <p:spPr>
          <a:xfrm>
            <a:off x="11780345" y="9581781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128" name="Connecteur droit 127">
            <a:extLst>
              <a:ext uri="{FF2B5EF4-FFF2-40B4-BE49-F238E27FC236}">
                <a16:creationId xmlns:a16="http://schemas.microsoft.com/office/drawing/2014/main" id="{5E09DBBA-9FE8-469C-BFBB-F0205A0B1EFB}"/>
              </a:ext>
            </a:extLst>
          </p:cNvPr>
          <p:cNvCxnSpPr>
            <a:cxnSpLocks/>
          </p:cNvCxnSpPr>
          <p:nvPr/>
        </p:nvCxnSpPr>
        <p:spPr>
          <a:xfrm>
            <a:off x="10566998" y="9518276"/>
            <a:ext cx="33643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0" name="Connecteur droit 129">
            <a:extLst>
              <a:ext uri="{FF2B5EF4-FFF2-40B4-BE49-F238E27FC236}">
                <a16:creationId xmlns:a16="http://schemas.microsoft.com/office/drawing/2014/main" id="{7B429045-9C95-4B8C-9CB6-70326539CD3E}"/>
              </a:ext>
            </a:extLst>
          </p:cNvPr>
          <p:cNvCxnSpPr>
            <a:cxnSpLocks/>
          </p:cNvCxnSpPr>
          <p:nvPr/>
        </p:nvCxnSpPr>
        <p:spPr>
          <a:xfrm>
            <a:off x="10117145" y="9518276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2" name="ZoneTexte 131">
            <a:extLst>
              <a:ext uri="{FF2B5EF4-FFF2-40B4-BE49-F238E27FC236}">
                <a16:creationId xmlns:a16="http://schemas.microsoft.com/office/drawing/2014/main" id="{4933B184-CFA0-4A88-A492-D208384E5BBF}"/>
              </a:ext>
            </a:extLst>
          </p:cNvPr>
          <p:cNvSpPr txBox="1"/>
          <p:nvPr/>
        </p:nvSpPr>
        <p:spPr>
          <a:xfrm>
            <a:off x="14554454" y="9567525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134" name="ZoneTexte 133">
            <a:extLst>
              <a:ext uri="{FF2B5EF4-FFF2-40B4-BE49-F238E27FC236}">
                <a16:creationId xmlns:a16="http://schemas.microsoft.com/office/drawing/2014/main" id="{DC87D994-3E6B-4B34-91D2-C13922740190}"/>
              </a:ext>
            </a:extLst>
          </p:cNvPr>
          <p:cNvSpPr txBox="1"/>
          <p:nvPr/>
        </p:nvSpPr>
        <p:spPr>
          <a:xfrm>
            <a:off x="16497160" y="9567525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136" name="Connecteur droit 135">
            <a:extLst>
              <a:ext uri="{FF2B5EF4-FFF2-40B4-BE49-F238E27FC236}">
                <a16:creationId xmlns:a16="http://schemas.microsoft.com/office/drawing/2014/main" id="{8166B6AF-006F-4505-A230-8E279ACC4DC8}"/>
              </a:ext>
            </a:extLst>
          </p:cNvPr>
          <p:cNvCxnSpPr>
            <a:cxnSpLocks/>
          </p:cNvCxnSpPr>
          <p:nvPr/>
        </p:nvCxnSpPr>
        <p:spPr>
          <a:xfrm>
            <a:off x="15283813" y="9504020"/>
            <a:ext cx="33643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8" name="Connecteur droit 137">
            <a:extLst>
              <a:ext uri="{FF2B5EF4-FFF2-40B4-BE49-F238E27FC236}">
                <a16:creationId xmlns:a16="http://schemas.microsoft.com/office/drawing/2014/main" id="{CCEA2358-D38C-4C5C-B911-FBD8DB206B73}"/>
              </a:ext>
            </a:extLst>
          </p:cNvPr>
          <p:cNvCxnSpPr>
            <a:cxnSpLocks/>
          </p:cNvCxnSpPr>
          <p:nvPr/>
        </p:nvCxnSpPr>
        <p:spPr>
          <a:xfrm>
            <a:off x="14833960" y="9504020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ZoneTexte 78">
            <a:extLst>
              <a:ext uri="{FF2B5EF4-FFF2-40B4-BE49-F238E27FC236}">
                <a16:creationId xmlns:a16="http://schemas.microsoft.com/office/drawing/2014/main" id="{722FF530-7C35-4127-96D2-51610B933F30}"/>
              </a:ext>
            </a:extLst>
          </p:cNvPr>
          <p:cNvSpPr txBox="1"/>
          <p:nvPr/>
        </p:nvSpPr>
        <p:spPr>
          <a:xfrm>
            <a:off x="394934" y="13047243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81" name="ZoneTexte 80">
            <a:extLst>
              <a:ext uri="{FF2B5EF4-FFF2-40B4-BE49-F238E27FC236}">
                <a16:creationId xmlns:a16="http://schemas.microsoft.com/office/drawing/2014/main" id="{7D40B932-F004-40A3-B74B-28D39AC4B202}"/>
              </a:ext>
            </a:extLst>
          </p:cNvPr>
          <p:cNvSpPr txBox="1"/>
          <p:nvPr/>
        </p:nvSpPr>
        <p:spPr>
          <a:xfrm>
            <a:off x="2390395" y="13047243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83" name="Connecteur droit 82">
            <a:extLst>
              <a:ext uri="{FF2B5EF4-FFF2-40B4-BE49-F238E27FC236}">
                <a16:creationId xmlns:a16="http://schemas.microsoft.com/office/drawing/2014/main" id="{138B5717-80C6-4DBD-83F1-997FE5A4BD9E}"/>
              </a:ext>
            </a:extLst>
          </p:cNvPr>
          <p:cNvCxnSpPr>
            <a:cxnSpLocks/>
          </p:cNvCxnSpPr>
          <p:nvPr/>
        </p:nvCxnSpPr>
        <p:spPr>
          <a:xfrm>
            <a:off x="1177048" y="12983738"/>
            <a:ext cx="336439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Connecteur droit 84">
            <a:extLst>
              <a:ext uri="{FF2B5EF4-FFF2-40B4-BE49-F238E27FC236}">
                <a16:creationId xmlns:a16="http://schemas.microsoft.com/office/drawing/2014/main" id="{052E276E-1E49-4F6F-B37A-312531F128BF}"/>
              </a:ext>
            </a:extLst>
          </p:cNvPr>
          <p:cNvCxnSpPr>
            <a:cxnSpLocks/>
          </p:cNvCxnSpPr>
          <p:nvPr/>
        </p:nvCxnSpPr>
        <p:spPr>
          <a:xfrm>
            <a:off x="674440" y="12983738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ZoneTexte 17">
            <a:extLst>
              <a:ext uri="{FF2B5EF4-FFF2-40B4-BE49-F238E27FC236}">
                <a16:creationId xmlns:a16="http://schemas.microsoft.com/office/drawing/2014/main" id="{9F80BE56-ACC9-4F9B-934C-263D72229D67}"/>
              </a:ext>
            </a:extLst>
          </p:cNvPr>
          <p:cNvSpPr txBox="1"/>
          <p:nvPr/>
        </p:nvSpPr>
        <p:spPr>
          <a:xfrm>
            <a:off x="394684" y="13411200"/>
            <a:ext cx="4967205" cy="5787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/>
              <a:t>Additional</a:t>
            </a:r>
            <a:r>
              <a:rPr lang="fr-FR" dirty="0"/>
              <a:t> Figure S2</a:t>
            </a:r>
          </a:p>
        </p:txBody>
      </p:sp>
    </p:spTree>
    <p:extLst>
      <p:ext uri="{BB962C8B-B14F-4D97-AF65-F5344CB8AC3E}">
        <p14:creationId xmlns:p14="http://schemas.microsoft.com/office/powerpoint/2010/main" val="348403113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0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3</TotalTime>
  <Words>51</Words>
  <Application>Microsoft Office PowerPoint</Application>
  <PresentationFormat>Personnalisé</PresentationFormat>
  <Paragraphs>4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CHRU Montpelli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AYREFOURCQ LAURE</dc:creator>
  <cp:lastModifiedBy>Laure Cayrefourcq</cp:lastModifiedBy>
  <cp:revision>15</cp:revision>
  <dcterms:created xsi:type="dcterms:W3CDTF">2019-12-16T14:45:07Z</dcterms:created>
  <dcterms:modified xsi:type="dcterms:W3CDTF">2020-08-07T08:12:16Z</dcterms:modified>
</cp:coreProperties>
</file>